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9" r:id="rId2"/>
    <p:sldId id="290" r:id="rId3"/>
    <p:sldId id="291" r:id="rId4"/>
    <p:sldId id="292" r:id="rId5"/>
    <p:sldId id="293" r:id="rId6"/>
    <p:sldId id="294" r:id="rId7"/>
    <p:sldId id="295" r:id="rId8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C7B10"/>
    <a:srgbClr val="9B5DAF"/>
    <a:srgbClr val="A459B3"/>
    <a:srgbClr val="AA64B8"/>
    <a:srgbClr val="A552CA"/>
    <a:srgbClr val="B091D9"/>
    <a:srgbClr val="B19AD0"/>
    <a:srgbClr val="FF860D"/>
    <a:srgbClr val="F29B1A"/>
    <a:srgbClr val="F5861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801" autoAdjust="0"/>
  </p:normalViewPr>
  <p:slideViewPr>
    <p:cSldViewPr>
      <p:cViewPr>
        <p:scale>
          <a:sx n="116" d="100"/>
          <a:sy n="116" d="100"/>
        </p:scale>
        <p:origin x="-660" y="19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ata\5%20NAL1\1%20NAL1_&#26434;&#31181;&#20248;&#21183;\NAL1_Heterosis&#20316;&#22270;&#25968;&#25454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ata\5%20NAL1\1%20NAL1_&#26434;&#31181;&#20248;&#21183;\NAL1_Heterosis&#20316;&#22270;&#25968;&#25454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ata\5%20NAL1\1%20NAL1_&#26434;&#31181;&#20248;&#21183;\NAL1_Heterosis&#20316;&#22270;&#25968;&#25454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ata\5%20NAL1\1%20NAL1_&#26434;&#31181;&#20248;&#21183;\NAL1_Heterosis&#20316;&#22270;&#25968;&#25454;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ata\5%20NAL1\1%20NAL1_&#26434;&#31181;&#20248;&#21183;\NAL1_Heterosis&#20316;&#22270;&#25968;&#25454;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ata\5%20NAL1\1%20NAL1_&#26434;&#31181;&#20248;&#21183;\NAL1_Heterosis&#20316;&#22270;&#25968;&#25454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448600174978128"/>
          <c:y val="5.9470710674992565E-2"/>
          <c:w val="0.77422593283295726"/>
          <c:h val="0.7272768424018362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Y$23:$Y$25</c:f>
                <c:numCache>
                  <c:formatCode>General</c:formatCode>
                  <c:ptCount val="3"/>
                  <c:pt idx="0">
                    <c:v>0.70339178272140723</c:v>
                  </c:pt>
                  <c:pt idx="1">
                    <c:v>0.7163867670469628</c:v>
                  </c:pt>
                  <c:pt idx="2">
                    <c:v>1.2452581169290875</c:v>
                  </c:pt>
                </c:numCache>
              </c:numRef>
            </c:plus>
            <c:minus>
              <c:numRef>
                <c:f>Sheet1!$Y$23:$Y$25</c:f>
                <c:numCache>
                  <c:formatCode>General</c:formatCode>
                  <c:ptCount val="3"/>
                  <c:pt idx="0">
                    <c:v>0.70339178272140723</c:v>
                  </c:pt>
                  <c:pt idx="1">
                    <c:v>0.7163867670469628</c:v>
                  </c:pt>
                  <c:pt idx="2">
                    <c:v>1.2452581169290875</c:v>
                  </c:pt>
                </c:numCache>
              </c:numRef>
            </c:minus>
          </c:errBars>
          <c:cat>
            <c:strRef>
              <c:f>Sheet1!$W$23:$W$25</c:f>
              <c:strCache>
                <c:ptCount val="3"/>
                <c:pt idx="0">
                  <c:v>9311</c:v>
                </c:pt>
                <c:pt idx="1">
                  <c:v>Hybrid</c:v>
                </c:pt>
                <c:pt idx="2">
                  <c:v>9311-NIL</c:v>
                </c:pt>
              </c:strCache>
            </c:strRef>
          </c:cat>
          <c:val>
            <c:numRef>
              <c:f>Sheet1!$X$23:$X$25</c:f>
              <c:numCache>
                <c:formatCode>###0.0000</c:formatCode>
                <c:ptCount val="3"/>
                <c:pt idx="0">
                  <c:v>28.886000000000003</c:v>
                </c:pt>
                <c:pt idx="1">
                  <c:v>28.159000000000002</c:v>
                </c:pt>
                <c:pt idx="2">
                  <c:v>29.1769999999999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0268544"/>
        <c:axId val="60425344"/>
      </c:barChart>
      <c:catAx>
        <c:axId val="60268544"/>
        <c:scaling>
          <c:orientation val="minMax"/>
        </c:scaling>
        <c:delete val="0"/>
        <c:axPos val="b"/>
        <c:majorTickMark val="out"/>
        <c:minorTickMark val="none"/>
        <c:tickLblPos val="nextTo"/>
        <c:crossAx val="60425344"/>
        <c:crosses val="autoZero"/>
        <c:auto val="1"/>
        <c:lblAlgn val="ctr"/>
        <c:lblOffset val="100"/>
        <c:noMultiLvlLbl val="0"/>
      </c:catAx>
      <c:valAx>
        <c:axId val="60425344"/>
        <c:scaling>
          <c:orientation val="minMax"/>
          <c:min val="0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crossAx val="60268544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zh-CN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617791745330079"/>
          <c:y val="5.8092241636280052E-2"/>
          <c:w val="0.77456456923147776"/>
          <c:h val="0.714234200168177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Y$68:$Y$70</c:f>
                <c:numCache>
                  <c:formatCode>General</c:formatCode>
                  <c:ptCount val="3"/>
                  <c:pt idx="0">
                    <c:v>1.229128611194592</c:v>
                  </c:pt>
                  <c:pt idx="1">
                    <c:v>1.0447647263060387</c:v>
                  </c:pt>
                  <c:pt idx="2">
                    <c:v>1.15854588663055</c:v>
                  </c:pt>
                </c:numCache>
              </c:numRef>
            </c:plus>
            <c:minus>
              <c:numRef>
                <c:f>Sheet1!$Y$68:$Y$70</c:f>
                <c:numCache>
                  <c:formatCode>General</c:formatCode>
                  <c:ptCount val="3"/>
                  <c:pt idx="0">
                    <c:v>1.229128611194592</c:v>
                  </c:pt>
                  <c:pt idx="1">
                    <c:v>1.0447647263060387</c:v>
                  </c:pt>
                  <c:pt idx="2">
                    <c:v>1.15854588663055</c:v>
                  </c:pt>
                </c:numCache>
              </c:numRef>
            </c:minus>
          </c:errBars>
          <c:cat>
            <c:strRef>
              <c:f>Sheet1!$W$68:$W$70</c:f>
              <c:strCache>
                <c:ptCount val="3"/>
                <c:pt idx="0">
                  <c:v>9311</c:v>
                </c:pt>
                <c:pt idx="1">
                  <c:v>Hybrid</c:v>
                </c:pt>
                <c:pt idx="2">
                  <c:v>9311-NIL</c:v>
                </c:pt>
              </c:strCache>
            </c:strRef>
          </c:cat>
          <c:val>
            <c:numRef>
              <c:f>Sheet1!$X$68:$X$70</c:f>
              <c:numCache>
                <c:formatCode>###0.0000</c:formatCode>
                <c:ptCount val="3"/>
                <c:pt idx="0">
                  <c:v>28.987142857142853</c:v>
                </c:pt>
                <c:pt idx="1">
                  <c:v>28.479999999999997</c:v>
                </c:pt>
                <c:pt idx="2">
                  <c:v>29.29428571428571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0269056"/>
        <c:axId val="60427072"/>
      </c:barChart>
      <c:catAx>
        <c:axId val="60269056"/>
        <c:scaling>
          <c:orientation val="minMax"/>
        </c:scaling>
        <c:delete val="0"/>
        <c:axPos val="b"/>
        <c:majorTickMark val="out"/>
        <c:minorTickMark val="none"/>
        <c:tickLblPos val="nextTo"/>
        <c:crossAx val="60427072"/>
        <c:crosses val="autoZero"/>
        <c:auto val="1"/>
        <c:lblAlgn val="ctr"/>
        <c:lblOffset val="100"/>
        <c:noMultiLvlLbl val="0"/>
      </c:catAx>
      <c:valAx>
        <c:axId val="60427072"/>
        <c:scaling>
          <c:orientation val="minMax"/>
          <c:min val="0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crossAx val="60269056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zh-CN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110391090105032"/>
          <c:y val="4.2613037313523276E-2"/>
          <c:w val="0.76257911551932656"/>
          <c:h val="0.8149066253014530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Y$173:$Y$175</c:f>
                <c:numCache>
                  <c:formatCode>General</c:formatCode>
                  <c:ptCount val="3"/>
                  <c:pt idx="0">
                    <c:v>0.22765889270698708</c:v>
                  </c:pt>
                  <c:pt idx="1">
                    <c:v>0.33071351434652391</c:v>
                  </c:pt>
                  <c:pt idx="2">
                    <c:v>0.31897156165222168</c:v>
                  </c:pt>
                </c:numCache>
              </c:numRef>
            </c:plus>
            <c:minus>
              <c:numRef>
                <c:f>Sheet1!$Y$173:$Y$175</c:f>
                <c:numCache>
                  <c:formatCode>General</c:formatCode>
                  <c:ptCount val="3"/>
                  <c:pt idx="0">
                    <c:v>0.22765889270698708</c:v>
                  </c:pt>
                  <c:pt idx="1">
                    <c:v>0.33071351434652391</c:v>
                  </c:pt>
                  <c:pt idx="2">
                    <c:v>0.31897156165222168</c:v>
                  </c:pt>
                </c:numCache>
              </c:numRef>
            </c:minus>
          </c:errBars>
          <c:cat>
            <c:strRef>
              <c:f>Sheet1!$W$173:$W$175</c:f>
              <c:strCache>
                <c:ptCount val="3"/>
                <c:pt idx="0">
                  <c:v>9311</c:v>
                </c:pt>
                <c:pt idx="1">
                  <c:v>Hybrid</c:v>
                </c:pt>
                <c:pt idx="2">
                  <c:v>9311-NIL</c:v>
                </c:pt>
              </c:strCache>
            </c:strRef>
          </c:cat>
          <c:val>
            <c:numRef>
              <c:f>Sheet1!$X$173:$X$175</c:f>
              <c:numCache>
                <c:formatCode>###0.0000</c:formatCode>
                <c:ptCount val="3"/>
                <c:pt idx="0">
                  <c:v>3.16</c:v>
                </c:pt>
                <c:pt idx="1">
                  <c:v>3.0399999999999996</c:v>
                </c:pt>
                <c:pt idx="2">
                  <c:v>2.98999999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9708928"/>
        <c:axId val="60429376"/>
      </c:barChart>
      <c:catAx>
        <c:axId val="59708928"/>
        <c:scaling>
          <c:orientation val="minMax"/>
        </c:scaling>
        <c:delete val="0"/>
        <c:axPos val="b"/>
        <c:majorTickMark val="out"/>
        <c:minorTickMark val="none"/>
        <c:tickLblPos val="nextTo"/>
        <c:crossAx val="60429376"/>
        <c:crosses val="autoZero"/>
        <c:auto val="1"/>
        <c:lblAlgn val="ctr"/>
        <c:lblOffset val="100"/>
        <c:noMultiLvlLbl val="0"/>
      </c:catAx>
      <c:valAx>
        <c:axId val="60429376"/>
        <c:scaling>
          <c:orientation val="minMax"/>
          <c:min val="0"/>
        </c:scaling>
        <c:delete val="0"/>
        <c:axPos val="l"/>
        <c:numFmt formatCode="#,##0.00_);[Red]\(#,##0.00\)" sourceLinked="0"/>
        <c:majorTickMark val="out"/>
        <c:minorTickMark val="none"/>
        <c:tickLblPos val="nextTo"/>
        <c:crossAx val="59708928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zh-CN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226377952755905"/>
          <c:y val="5.1272965879265095E-2"/>
          <c:w val="0.71662510936132984"/>
          <c:h val="0.735971857684456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Y$192:$Y$194</c:f>
                <c:numCache>
                  <c:formatCode>General</c:formatCode>
                  <c:ptCount val="3"/>
                  <c:pt idx="0">
                    <c:v>6.6039717794325135E-4</c:v>
                  </c:pt>
                  <c:pt idx="1">
                    <c:v>9.8146133078235473E-4</c:v>
                  </c:pt>
                  <c:pt idx="2">
                    <c:v>1.3357665223283318E-3</c:v>
                  </c:pt>
                </c:numCache>
              </c:numRef>
            </c:plus>
            <c:minus>
              <c:numRef>
                <c:f>Sheet1!$Y$192:$Y$194</c:f>
                <c:numCache>
                  <c:formatCode>General</c:formatCode>
                  <c:ptCount val="3"/>
                  <c:pt idx="0">
                    <c:v>6.6039717794325135E-4</c:v>
                  </c:pt>
                  <c:pt idx="1">
                    <c:v>9.8146133078235473E-4</c:v>
                  </c:pt>
                  <c:pt idx="2">
                    <c:v>1.3357665223283318E-3</c:v>
                  </c:pt>
                </c:numCache>
              </c:numRef>
            </c:minus>
          </c:errBars>
          <c:cat>
            <c:strRef>
              <c:f>Sheet1!$W$192:$W$194</c:f>
              <c:strCache>
                <c:ptCount val="3"/>
                <c:pt idx="0">
                  <c:v>9311</c:v>
                </c:pt>
                <c:pt idx="1">
                  <c:v>Hybrid</c:v>
                </c:pt>
                <c:pt idx="2">
                  <c:v>9311-NIL</c:v>
                </c:pt>
              </c:strCache>
            </c:strRef>
          </c:cat>
          <c:val>
            <c:numRef>
              <c:f>Sheet1!$X$192:$X$194</c:f>
              <c:numCache>
                <c:formatCode>####.0000000</c:formatCode>
                <c:ptCount val="3"/>
                <c:pt idx="0">
                  <c:v>9.4369486250000002E-3</c:v>
                </c:pt>
                <c:pt idx="1">
                  <c:v>1.115712975E-2</c:v>
                </c:pt>
                <c:pt idx="2">
                  <c:v>1.2457936374999999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9709440"/>
        <c:axId val="60431104"/>
      </c:barChart>
      <c:catAx>
        <c:axId val="59709440"/>
        <c:scaling>
          <c:orientation val="minMax"/>
        </c:scaling>
        <c:delete val="0"/>
        <c:axPos val="b"/>
        <c:majorTickMark val="out"/>
        <c:minorTickMark val="none"/>
        <c:tickLblPos val="nextTo"/>
        <c:crossAx val="60431104"/>
        <c:crosses val="autoZero"/>
        <c:auto val="1"/>
        <c:lblAlgn val="ctr"/>
        <c:lblOffset val="100"/>
        <c:noMultiLvlLbl val="0"/>
      </c:catAx>
      <c:valAx>
        <c:axId val="60431104"/>
        <c:scaling>
          <c:orientation val="minMax"/>
        </c:scaling>
        <c:delete val="0"/>
        <c:axPos val="l"/>
        <c:numFmt formatCode="#,##0.000_);[Red]\(#,##0.000\)" sourceLinked="0"/>
        <c:majorTickMark val="out"/>
        <c:minorTickMark val="none"/>
        <c:tickLblPos val="nextTo"/>
        <c:crossAx val="59709440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zh-CN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66453596700532"/>
          <c:y val="5.5911776327453505E-2"/>
          <c:w val="0.79860928915089069"/>
          <c:h val="0.7571424141936375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L$295:$L$297</c:f>
                <c:numCache>
                  <c:formatCode>General</c:formatCode>
                  <c:ptCount val="3"/>
                  <c:pt idx="0">
                    <c:v>3.0672618470054447</c:v>
                  </c:pt>
                  <c:pt idx="1">
                    <c:v>4.51252225954146</c:v>
                  </c:pt>
                  <c:pt idx="2">
                    <c:v>3.1269946015455865</c:v>
                  </c:pt>
                </c:numCache>
              </c:numRef>
            </c:plus>
            <c:minus>
              <c:numRef>
                <c:f>Sheet1!$L$295:$L$297</c:f>
                <c:numCache>
                  <c:formatCode>General</c:formatCode>
                  <c:ptCount val="3"/>
                  <c:pt idx="0">
                    <c:v>3.0672618470054447</c:v>
                  </c:pt>
                  <c:pt idx="1">
                    <c:v>4.51252225954146</c:v>
                  </c:pt>
                  <c:pt idx="2">
                    <c:v>3.1269946015455865</c:v>
                  </c:pt>
                </c:numCache>
              </c:numRef>
            </c:minus>
          </c:errBars>
          <c:cat>
            <c:strRef>
              <c:f>Sheet1!$J$295:$J$297</c:f>
              <c:strCache>
                <c:ptCount val="3"/>
                <c:pt idx="0">
                  <c:v>9311</c:v>
                </c:pt>
                <c:pt idx="1">
                  <c:v>Hybrid</c:v>
                </c:pt>
                <c:pt idx="2">
                  <c:v>9311-NIL</c:v>
                </c:pt>
              </c:strCache>
            </c:strRef>
          </c:cat>
          <c:val>
            <c:numRef>
              <c:f>Sheet1!$K$295:$K$297</c:f>
              <c:numCache>
                <c:formatCode>###0.0000</c:formatCode>
                <c:ptCount val="3"/>
                <c:pt idx="0">
                  <c:v>117.98571428571429</c:v>
                </c:pt>
                <c:pt idx="1">
                  <c:v>120.05714285714285</c:v>
                </c:pt>
                <c:pt idx="2">
                  <c:v>116.885714285714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9813376"/>
        <c:axId val="60466304"/>
      </c:barChart>
      <c:catAx>
        <c:axId val="59813376"/>
        <c:scaling>
          <c:orientation val="minMax"/>
        </c:scaling>
        <c:delete val="0"/>
        <c:axPos val="b"/>
        <c:majorTickMark val="out"/>
        <c:minorTickMark val="none"/>
        <c:tickLblPos val="nextTo"/>
        <c:crossAx val="60466304"/>
        <c:crosses val="autoZero"/>
        <c:auto val="1"/>
        <c:lblAlgn val="ctr"/>
        <c:lblOffset val="100"/>
        <c:noMultiLvlLbl val="0"/>
      </c:catAx>
      <c:valAx>
        <c:axId val="60466304"/>
        <c:scaling>
          <c:orientation val="minMax"/>
          <c:min val="0"/>
        </c:scaling>
        <c:delete val="0"/>
        <c:axPos val="l"/>
        <c:numFmt formatCode="#,##0_);[Red]\(#,##0\)" sourceLinked="0"/>
        <c:majorTickMark val="out"/>
        <c:minorTickMark val="none"/>
        <c:tickLblPos val="nextTo"/>
        <c:crossAx val="59813376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zh-CN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523135996889278"/>
          <c:y val="0.10185185185185185"/>
          <c:w val="0.78084135316418779"/>
          <c:h val="0.6804163021289005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K$321:$K$323</c:f>
                <c:numCache>
                  <c:formatCode>General</c:formatCode>
                  <c:ptCount val="3"/>
                  <c:pt idx="0">
                    <c:v>0.17665984000000001</c:v>
                  </c:pt>
                  <c:pt idx="1">
                    <c:v>0.12077789999999999</c:v>
                  </c:pt>
                  <c:pt idx="2">
                    <c:v>7.8692440000000002E-2</c:v>
                  </c:pt>
                </c:numCache>
              </c:numRef>
            </c:plus>
            <c:minus>
              <c:numRef>
                <c:f>Sheet1!$K$321:$K$323</c:f>
                <c:numCache>
                  <c:formatCode>General</c:formatCode>
                  <c:ptCount val="3"/>
                  <c:pt idx="0">
                    <c:v>0.17665984000000001</c:v>
                  </c:pt>
                  <c:pt idx="1">
                    <c:v>0.12077789999999999</c:v>
                  </c:pt>
                  <c:pt idx="2">
                    <c:v>7.8692440000000002E-2</c:v>
                  </c:pt>
                </c:numCache>
              </c:numRef>
            </c:minus>
          </c:errBars>
          <c:cat>
            <c:strRef>
              <c:f>Sheet1!$I$321:$I$323</c:f>
              <c:strCache>
                <c:ptCount val="3"/>
                <c:pt idx="0">
                  <c:v>9311</c:v>
                </c:pt>
                <c:pt idx="1">
                  <c:v>Hybrid</c:v>
                </c:pt>
                <c:pt idx="2">
                  <c:v>9311-NIL</c:v>
                </c:pt>
              </c:strCache>
            </c:strRef>
          </c:cat>
          <c:val>
            <c:numRef>
              <c:f>Sheet1!$J$321:$J$323</c:f>
              <c:numCache>
                <c:formatCode>####.0000000</c:formatCode>
                <c:ptCount val="3"/>
                <c:pt idx="0" formatCode="###0.0000000">
                  <c:v>1.0458000000000001</c:v>
                </c:pt>
                <c:pt idx="1">
                  <c:v>0.76539999999999997</c:v>
                </c:pt>
                <c:pt idx="2">
                  <c:v>0.423999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9889152"/>
        <c:axId val="60469184"/>
      </c:barChart>
      <c:catAx>
        <c:axId val="59889152"/>
        <c:scaling>
          <c:orientation val="minMax"/>
        </c:scaling>
        <c:delete val="0"/>
        <c:axPos val="b"/>
        <c:majorTickMark val="out"/>
        <c:minorTickMark val="none"/>
        <c:tickLblPos val="nextTo"/>
        <c:crossAx val="60469184"/>
        <c:crosses val="autoZero"/>
        <c:auto val="1"/>
        <c:lblAlgn val="ctr"/>
        <c:lblOffset val="100"/>
        <c:noMultiLvlLbl val="0"/>
      </c:catAx>
      <c:valAx>
        <c:axId val="60469184"/>
        <c:scaling>
          <c:orientation val="minMax"/>
        </c:scaling>
        <c:delete val="0"/>
        <c:axPos val="l"/>
        <c:numFmt formatCode="#,##0.00_);[Red]\(#,##0.00\)" sourceLinked="0"/>
        <c:majorTickMark val="out"/>
        <c:minorTickMark val="none"/>
        <c:tickLblPos val="nextTo"/>
        <c:crossAx val="59889152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zh-CN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1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1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1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4/1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图表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3057764"/>
              </p:ext>
            </p:extLst>
          </p:nvPr>
        </p:nvGraphicFramePr>
        <p:xfrm>
          <a:off x="3432400" y="1615664"/>
          <a:ext cx="2084832" cy="12300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4" name="图表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80659198"/>
              </p:ext>
            </p:extLst>
          </p:nvPr>
        </p:nvGraphicFramePr>
        <p:xfrm>
          <a:off x="1298971" y="1615662"/>
          <a:ext cx="2084832" cy="12425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TextBox 10"/>
          <p:cNvSpPr txBox="1"/>
          <p:nvPr/>
        </p:nvSpPr>
        <p:spPr>
          <a:xfrm rot="16200000">
            <a:off x="690406" y="2031870"/>
            <a:ext cx="10881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GW (g)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112551" y="2765998"/>
            <a:ext cx="7736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 smtClean="0"/>
              <a:t>2022</a:t>
            </a:r>
            <a:endParaRPr lang="zh-CN" altLang="en-US" sz="1400" dirty="0"/>
          </a:p>
        </p:txBody>
      </p:sp>
      <p:sp>
        <p:nvSpPr>
          <p:cNvPr id="27" name="TextBox 26"/>
          <p:cNvSpPr txBox="1"/>
          <p:nvPr/>
        </p:nvSpPr>
        <p:spPr>
          <a:xfrm>
            <a:off x="4249149" y="2765997"/>
            <a:ext cx="7736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 smtClean="0"/>
              <a:t>2023</a:t>
            </a:r>
            <a:endParaRPr lang="zh-CN" altLang="en-US" sz="1400" dirty="0"/>
          </a:p>
        </p:txBody>
      </p:sp>
      <p:sp>
        <p:nvSpPr>
          <p:cNvPr id="39" name="TextBox 38"/>
          <p:cNvSpPr txBox="1"/>
          <p:nvPr/>
        </p:nvSpPr>
        <p:spPr>
          <a:xfrm>
            <a:off x="678065" y="3721847"/>
            <a:ext cx="55590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 smtClean="0">
                <a:latin typeface="Times New Roman" pitchFamily="18" charset="0"/>
                <a:cs typeface="Times New Roman" pitchFamily="18" charset="0"/>
              </a:rPr>
              <a:t>Fig. S1 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thousand grain weight (TGW) among 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three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L1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lines 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grown in two consecutive growth seasons </a:t>
            </a:r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2022 (a) and 2023 (b) 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at Changsha. The values represent mean ±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.d.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 = 10). 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106102" y="1547664"/>
            <a:ext cx="341755" cy="18498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252231" y="1547664"/>
            <a:ext cx="341755" cy="18498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42526" y="611560"/>
            <a:ext cx="2625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upplementary Dat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922990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/>
          <p:cNvSpPr txBox="1"/>
          <p:nvPr/>
        </p:nvSpPr>
        <p:spPr>
          <a:xfrm>
            <a:off x="678065" y="3834903"/>
            <a:ext cx="55590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 smtClean="0">
                <a:latin typeface="Times New Roman" pitchFamily="18" charset="0"/>
                <a:cs typeface="Times New Roman" pitchFamily="18" charset="0"/>
              </a:rPr>
              <a:t>Fig. S2</a:t>
            </a:r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The flag </a:t>
            </a:r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leaf N status in three </a:t>
            </a:r>
            <a:r>
              <a:rPr lang="en-US" altLang="zh-CN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AL1</a:t>
            </a:r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 lines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(a), 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Total N </a:t>
            </a:r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content. (b), Total 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N </a:t>
            </a:r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accumulation.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31" name="图表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48770009"/>
              </p:ext>
            </p:extLst>
          </p:nvPr>
        </p:nvGraphicFramePr>
        <p:xfrm>
          <a:off x="1307075" y="1680677"/>
          <a:ext cx="2025859" cy="11882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7" name="TextBox 36"/>
          <p:cNvSpPr txBox="1"/>
          <p:nvPr/>
        </p:nvSpPr>
        <p:spPr>
          <a:xfrm rot="16200000">
            <a:off x="607835" y="2182325"/>
            <a:ext cx="12241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Times New Roman" pitchFamily="18" charset="0"/>
                <a:cs typeface="Times New Roman" panose="02020603050405020304" pitchFamily="18" charset="0"/>
              </a:rPr>
              <a:t>Leaf N content (%)</a:t>
            </a:r>
          </a:p>
        </p:txBody>
      </p:sp>
      <p:graphicFrame>
        <p:nvGraphicFramePr>
          <p:cNvPr id="43" name="图表 4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5044511"/>
              </p:ext>
            </p:extLst>
          </p:nvPr>
        </p:nvGraphicFramePr>
        <p:xfrm>
          <a:off x="3432170" y="1678546"/>
          <a:ext cx="2171700" cy="12070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4" name="TextBox 43"/>
          <p:cNvSpPr txBox="1"/>
          <p:nvPr/>
        </p:nvSpPr>
        <p:spPr>
          <a:xfrm rot="16200000">
            <a:off x="2694643" y="2201293"/>
            <a:ext cx="14368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itchFamily="18" charset="0"/>
                <a:cs typeface="Times New Roman" panose="02020603050405020304" pitchFamily="18" charset="0"/>
              </a:rPr>
              <a:t>Leaf </a:t>
            </a:r>
            <a:r>
              <a:rPr lang="en-US" altLang="zh-CN" sz="1000" dirty="0">
                <a:latin typeface="Times New Roman" pitchFamily="18" charset="0"/>
                <a:cs typeface="Times New Roman" panose="02020603050405020304" pitchFamily="18" charset="0"/>
              </a:rPr>
              <a:t>N uptake (g/plant</a:t>
            </a:r>
            <a:r>
              <a:rPr lang="en-US" altLang="zh-CN" sz="1000" dirty="0" smtClean="0">
                <a:latin typeface="Times New Roman" pitchFamily="18" charset="0"/>
                <a:cs typeface="Times New Roman" panose="02020603050405020304" pitchFamily="18" charset="0"/>
              </a:rPr>
              <a:t>)</a:t>
            </a:r>
            <a:endParaRPr lang="en-US" altLang="zh-CN" sz="1000" dirty="0">
              <a:latin typeface="Times New Roman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607475" y="1728601"/>
            <a:ext cx="2160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066414" y="1847217"/>
            <a:ext cx="2160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149631" y="1637543"/>
            <a:ext cx="2160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084157" y="1598869"/>
            <a:ext cx="341755" cy="18498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252231" y="1598869"/>
            <a:ext cx="341755" cy="18498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42526" y="611560"/>
            <a:ext cx="2625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upplementary Dat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0886327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763820" y="4067944"/>
            <a:ext cx="55590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growth performance of three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L1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ines. (a) Growth status at the grain filling stage (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le bar =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(b) Plant height. The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represent mean ±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.d.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 =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). 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" name="组合 9"/>
          <p:cNvGrpSpPr/>
          <p:nvPr/>
        </p:nvGrpSpPr>
        <p:grpSpPr>
          <a:xfrm>
            <a:off x="1516073" y="1776388"/>
            <a:ext cx="1517454" cy="1261545"/>
            <a:chOff x="3783754" y="1547664"/>
            <a:chExt cx="1610606" cy="1398349"/>
          </a:xfrm>
        </p:grpSpPr>
        <p:pic>
          <p:nvPicPr>
            <p:cNvPr id="34" name="Picture 2" descr="C:\Users\Administrator\Desktop\7R1A0115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90" r="1"/>
            <a:stretch/>
          </p:blipFill>
          <p:spPr bwMode="auto">
            <a:xfrm>
              <a:off x="3866992" y="1547664"/>
              <a:ext cx="1363088" cy="121460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35" name="直接连接符 34"/>
            <p:cNvCxnSpPr/>
            <p:nvPr/>
          </p:nvCxnSpPr>
          <p:spPr>
            <a:xfrm flipH="1">
              <a:off x="3889017" y="2611815"/>
              <a:ext cx="249491" cy="0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/>
            <p:cNvSpPr txBox="1"/>
            <p:nvPr/>
          </p:nvSpPr>
          <p:spPr>
            <a:xfrm>
              <a:off x="3812229" y="2448762"/>
              <a:ext cx="426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 smtClean="0">
                  <a:solidFill>
                    <a:srgbClr val="00B0F0"/>
                  </a:solidFill>
                  <a:latin typeface="Times New Roman" pitchFamily="18" charset="0"/>
                  <a:cs typeface="Times New Roman" pitchFamily="18" charset="0"/>
                </a:rPr>
                <a:t>25cm</a:t>
              </a:r>
              <a:endParaRPr lang="zh-CN" altLang="en-US" sz="700" dirty="0">
                <a:solidFill>
                  <a:srgbClr val="00B0F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783754" y="2699792"/>
              <a:ext cx="7451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itchFamily="18" charset="0"/>
                  <a:cs typeface="Times New Roman" pitchFamily="18" charset="0"/>
                </a:rPr>
                <a:t>9311</a:t>
              </a:r>
              <a:endParaRPr lang="zh-CN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154366" y="2699792"/>
              <a:ext cx="7451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itchFamily="18" charset="0"/>
                  <a:cs typeface="Times New Roman" pitchFamily="18" charset="0"/>
                </a:rPr>
                <a:t>Hybrid</a:t>
              </a:r>
              <a:endParaRPr lang="zh-CN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649247" y="2699792"/>
              <a:ext cx="7451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itchFamily="18" charset="0"/>
                  <a:cs typeface="Times New Roman" pitchFamily="18" charset="0"/>
                </a:rPr>
                <a:t>9311-NIL</a:t>
              </a:r>
              <a:endParaRPr lang="zh-CN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50" name="TextBox 49"/>
          <p:cNvSpPr txBox="1"/>
          <p:nvPr/>
        </p:nvSpPr>
        <p:spPr>
          <a:xfrm rot="16200000">
            <a:off x="2492703" y="2181160"/>
            <a:ext cx="12251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 height (cm)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9" name="图表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1031953"/>
              </p:ext>
            </p:extLst>
          </p:nvPr>
        </p:nvGraphicFramePr>
        <p:xfrm>
          <a:off x="3166933" y="1761079"/>
          <a:ext cx="2075375" cy="12326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1330935" y="1708131"/>
            <a:ext cx="341755" cy="18498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945124" y="1708131"/>
            <a:ext cx="341755" cy="18498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42526" y="611560"/>
            <a:ext cx="2625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upplementary Dat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6282174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748748" y="3923928"/>
            <a:ext cx="555902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4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analysis of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omic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among three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L1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. (a) Principal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onent analysis (PCA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(b)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nn diagrams of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ly expressed proteins (DEPs) in hybrid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s.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311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hybrid vs. 9311-NIL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e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ups.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EGs were identified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using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corrected value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0.05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og2 fold change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gt;1.5.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390434" y="1468341"/>
            <a:ext cx="2480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152531" y="2843808"/>
            <a:ext cx="13059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Hybrid_vs_9311-NIL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212609" y="2843808"/>
            <a:ext cx="12437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Hybrid_vs_9311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9" name="Picture 5" descr="C:\Users\Administrator\Desktop\Bud_Fold1.5P0.05_result\client708\Venn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36" t="22308" r="4972" b="17875"/>
          <a:stretch/>
        </p:blipFill>
        <p:spPr bwMode="auto">
          <a:xfrm>
            <a:off x="3350415" y="1518574"/>
            <a:ext cx="1950794" cy="12995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1320982" y="1516605"/>
            <a:ext cx="341755" cy="18498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252231" y="1516605"/>
            <a:ext cx="341755" cy="18498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379"/>
          <a:stretch/>
        </p:blipFill>
        <p:spPr bwMode="auto">
          <a:xfrm>
            <a:off x="1472251" y="1518575"/>
            <a:ext cx="1678348" cy="17483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242526" y="611560"/>
            <a:ext cx="2625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upplementary Dat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093765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Picture 5" descr="C:\Users\Administrator\Desktop\result\client708_up&amp;down\client.GO_Enrich.barplot_708_9311up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319" b="49053"/>
          <a:stretch/>
        </p:blipFill>
        <p:spPr bwMode="auto">
          <a:xfrm>
            <a:off x="1061799" y="4408228"/>
            <a:ext cx="3557588" cy="9744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9" name="Picture 4" descr="C:\Users\Administrator\Desktop\result\client708_up&amp;down\client.GO_Enrich.barplot_708_9311NILup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8409" r="16266" b="48873"/>
          <a:stretch/>
        </p:blipFill>
        <p:spPr bwMode="auto">
          <a:xfrm>
            <a:off x="1045421" y="6080084"/>
            <a:ext cx="3983819" cy="9765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矩形 4"/>
          <p:cNvSpPr/>
          <p:nvPr/>
        </p:nvSpPr>
        <p:spPr>
          <a:xfrm rot="19364180">
            <a:off x="976439" y="2269742"/>
            <a:ext cx="107753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single-organism metabol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矩形 5"/>
          <p:cNvSpPr/>
          <p:nvPr/>
        </p:nvSpPr>
        <p:spPr>
          <a:xfrm rot="19364180">
            <a:off x="3455065" y="2105712"/>
            <a:ext cx="53572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hem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binding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 rot="19364180">
            <a:off x="1308601" y="2188213"/>
            <a:ext cx="808234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single-organism </a:t>
            </a:r>
            <a:r>
              <a:rPr lang="en-US" altLang="zh-CN" sz="500" dirty="0" smtClean="0">
                <a:latin typeface="Times New Roman" pitchFamily="18" charset="0"/>
                <a:cs typeface="Times New Roman" pitchFamily="18" charset="0"/>
              </a:rPr>
              <a:t>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矩形 7"/>
          <p:cNvSpPr/>
          <p:nvPr/>
        </p:nvSpPr>
        <p:spPr>
          <a:xfrm rot="19364180">
            <a:off x="1548954" y="2139683"/>
            <a:ext cx="64793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smtClean="0">
                <a:latin typeface="Times New Roman" pitchFamily="18" charset="0"/>
                <a:cs typeface="Times New Roman" pitchFamily="18" charset="0"/>
              </a:rPr>
              <a:t>metabolic 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矩形 8"/>
          <p:cNvSpPr/>
          <p:nvPr/>
        </p:nvSpPr>
        <p:spPr>
          <a:xfrm rot="19364180">
            <a:off x="1357911" y="2235771"/>
            <a:ext cx="96532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fatty acid biosynthet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矩形 9"/>
          <p:cNvSpPr/>
          <p:nvPr/>
        </p:nvSpPr>
        <p:spPr>
          <a:xfrm rot="19364180">
            <a:off x="1510222" y="2217330"/>
            <a:ext cx="904414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fatty acid metabol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矩形 10"/>
          <p:cNvSpPr/>
          <p:nvPr/>
        </p:nvSpPr>
        <p:spPr>
          <a:xfrm rot="19364180">
            <a:off x="1481457" y="2259551"/>
            <a:ext cx="104387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ellular </a:t>
            </a:r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glucan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metabol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矩形 11"/>
          <p:cNvSpPr/>
          <p:nvPr/>
        </p:nvSpPr>
        <p:spPr>
          <a:xfrm rot="19364180">
            <a:off x="1715015" y="2245963"/>
            <a:ext cx="998991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arbohydrate metabol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矩形 12"/>
          <p:cNvSpPr/>
          <p:nvPr/>
        </p:nvSpPr>
        <p:spPr>
          <a:xfrm rot="19364180">
            <a:off x="2141454" y="2132404"/>
            <a:ext cx="62388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defense response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矩形 13"/>
          <p:cNvSpPr/>
          <p:nvPr/>
        </p:nvSpPr>
        <p:spPr>
          <a:xfrm rot="19364180">
            <a:off x="1931144" y="2234801"/>
            <a:ext cx="962122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defense response to bacterium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矩形 14"/>
          <p:cNvSpPr/>
          <p:nvPr/>
        </p:nvSpPr>
        <p:spPr>
          <a:xfrm rot="19364180">
            <a:off x="2100561" y="2210051"/>
            <a:ext cx="88036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defense response to </a:t>
            </a:r>
            <a:r>
              <a:rPr lang="en-US" altLang="zh-CN" sz="500" dirty="0" smtClean="0">
                <a:latin typeface="Times New Roman" pitchFamily="18" charset="0"/>
                <a:cs typeface="Times New Roman" pitchFamily="18" charset="0"/>
              </a:rPr>
              <a:t>fungu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矩形 15"/>
          <p:cNvSpPr/>
          <p:nvPr/>
        </p:nvSpPr>
        <p:spPr>
          <a:xfrm rot="19364180">
            <a:off x="2184441" y="2213448"/>
            <a:ext cx="891590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response to oxidative str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矩形 16"/>
          <p:cNvSpPr/>
          <p:nvPr/>
        </p:nvSpPr>
        <p:spPr>
          <a:xfrm rot="19364180">
            <a:off x="2327804" y="2202062"/>
            <a:ext cx="841897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lipid biosynthet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矩形 17"/>
          <p:cNvSpPr/>
          <p:nvPr/>
        </p:nvSpPr>
        <p:spPr>
          <a:xfrm rot="19364180">
            <a:off x="2393332" y="2243051"/>
            <a:ext cx="98937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ellular lipid metabol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矩形 18"/>
          <p:cNvSpPr/>
          <p:nvPr/>
        </p:nvSpPr>
        <p:spPr>
          <a:xfrm rot="19364180">
            <a:off x="2365447" y="2282360"/>
            <a:ext cx="111921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arboxylic acid biosynthet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矩形 19"/>
          <p:cNvSpPr/>
          <p:nvPr/>
        </p:nvSpPr>
        <p:spPr>
          <a:xfrm rot="19364180">
            <a:off x="2383363" y="2308081"/>
            <a:ext cx="120417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monocarboxylic acid metabol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矩形 20"/>
          <p:cNvSpPr/>
          <p:nvPr/>
        </p:nvSpPr>
        <p:spPr>
          <a:xfrm rot="19364180">
            <a:off x="2600357" y="2269742"/>
            <a:ext cx="107753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single-organism metabol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矩形 21"/>
          <p:cNvSpPr/>
          <p:nvPr/>
        </p:nvSpPr>
        <p:spPr>
          <a:xfrm rot="19364180">
            <a:off x="3081059" y="2136286"/>
            <a:ext cx="63671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response to str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矩形 22"/>
          <p:cNvSpPr/>
          <p:nvPr/>
        </p:nvSpPr>
        <p:spPr>
          <a:xfrm rot="19364180">
            <a:off x="3129868" y="2150845"/>
            <a:ext cx="68480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extracellular region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矩形 23"/>
          <p:cNvSpPr/>
          <p:nvPr/>
        </p:nvSpPr>
        <p:spPr>
          <a:xfrm rot="19364180">
            <a:off x="3482451" y="2065918"/>
            <a:ext cx="404277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ell wall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矩形 24"/>
          <p:cNvSpPr/>
          <p:nvPr/>
        </p:nvSpPr>
        <p:spPr>
          <a:xfrm rot="19364180">
            <a:off x="3332253" y="2180448"/>
            <a:ext cx="78258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oxidoreductas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矩形 25"/>
          <p:cNvSpPr/>
          <p:nvPr/>
        </p:nvSpPr>
        <p:spPr>
          <a:xfrm rot="19364180">
            <a:off x="3586675" y="2127811"/>
            <a:ext cx="596637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iron ion binding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矩形 26"/>
          <p:cNvSpPr/>
          <p:nvPr/>
        </p:nvSpPr>
        <p:spPr>
          <a:xfrm rot="19364180">
            <a:off x="3540231" y="2178768"/>
            <a:ext cx="76495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alpha-amylase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矩形 27"/>
          <p:cNvSpPr/>
          <p:nvPr/>
        </p:nvSpPr>
        <p:spPr>
          <a:xfrm rot="19364180">
            <a:off x="3183037" y="2332606"/>
            <a:ext cx="1273104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ellulose synthase (UDP-forming)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矩形 28"/>
          <p:cNvSpPr/>
          <p:nvPr/>
        </p:nvSpPr>
        <p:spPr>
          <a:xfrm rot="19364180">
            <a:off x="3850344" y="2258095"/>
            <a:ext cx="103906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UDP-</a:t>
            </a:r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glucosyltransferas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矩形 29"/>
          <p:cNvSpPr/>
          <p:nvPr/>
        </p:nvSpPr>
        <p:spPr>
          <a:xfrm rot="19364180">
            <a:off x="4276621" y="2146962"/>
            <a:ext cx="67197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peroxidase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矩形 30"/>
          <p:cNvSpPr/>
          <p:nvPr/>
        </p:nvSpPr>
        <p:spPr>
          <a:xfrm rot="19364180">
            <a:off x="4423197" y="2128521"/>
            <a:ext cx="611065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atalytic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矩形 31"/>
          <p:cNvSpPr/>
          <p:nvPr/>
        </p:nvSpPr>
        <p:spPr>
          <a:xfrm rot="19364180">
            <a:off x="4492587" y="2136286"/>
            <a:ext cx="63671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metal ion binding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矩形 35"/>
          <p:cNvSpPr/>
          <p:nvPr/>
        </p:nvSpPr>
        <p:spPr>
          <a:xfrm rot="19364180">
            <a:off x="1055508" y="2219532"/>
            <a:ext cx="899605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oxidation-reduction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矩形 36"/>
          <p:cNvSpPr/>
          <p:nvPr/>
        </p:nvSpPr>
        <p:spPr>
          <a:xfrm rot="19364180">
            <a:off x="1665615" y="2236032"/>
            <a:ext cx="954107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ellulose biosynthet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矩形 37"/>
          <p:cNvSpPr/>
          <p:nvPr/>
        </p:nvSpPr>
        <p:spPr>
          <a:xfrm rot="19364180">
            <a:off x="2243276" y="2262239"/>
            <a:ext cx="1040670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organic acid biosynthet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矩形 38"/>
          <p:cNvSpPr/>
          <p:nvPr/>
        </p:nvSpPr>
        <p:spPr>
          <a:xfrm rot="19364180">
            <a:off x="3794812" y="2161594"/>
            <a:ext cx="67197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transferas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矩形 39"/>
          <p:cNvSpPr/>
          <p:nvPr/>
        </p:nvSpPr>
        <p:spPr>
          <a:xfrm rot="19364180">
            <a:off x="3872286" y="2172565"/>
            <a:ext cx="697627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alcium ion binding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矩形 40"/>
          <p:cNvSpPr/>
          <p:nvPr/>
        </p:nvSpPr>
        <p:spPr>
          <a:xfrm rot="19364180">
            <a:off x="4170370" y="2091899"/>
            <a:ext cx="478015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smtClean="0">
                <a:latin typeface="Times New Roman" pitchFamily="18" charset="0"/>
                <a:cs typeface="Times New Roman" pitchFamily="18" charset="0"/>
              </a:rPr>
              <a:t>ion 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binding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矩形 41"/>
          <p:cNvSpPr/>
          <p:nvPr/>
        </p:nvSpPr>
        <p:spPr>
          <a:xfrm rot="19364180">
            <a:off x="3757470" y="2260594"/>
            <a:ext cx="103906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UDP-</a:t>
            </a:r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glycosyltransferas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Picture 2" descr="C:\Users\Administrator\Desktop\result\client708_up&amp;down\client.GO_Enrich.barplot_708_9311down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508" r="19273" b="49064"/>
          <a:stretch/>
        </p:blipFill>
        <p:spPr bwMode="auto">
          <a:xfrm>
            <a:off x="1047221" y="1109317"/>
            <a:ext cx="4082970" cy="9698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" name="Picture 3" descr="C:\Users\Administrator\Desktop\result\client708_up&amp;down\client.GO_Enrich.barplot_708_9311NILdown.pn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153" r="1768" b="49084"/>
          <a:stretch/>
        </p:blipFill>
        <p:spPr bwMode="auto">
          <a:xfrm>
            <a:off x="1045672" y="2769132"/>
            <a:ext cx="4280656" cy="9775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4" name="矩形 53"/>
          <p:cNvSpPr/>
          <p:nvPr/>
        </p:nvSpPr>
        <p:spPr>
          <a:xfrm rot="19364180">
            <a:off x="1029890" y="3887452"/>
            <a:ext cx="899605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oxidation-reduction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5" name="矩形 54"/>
          <p:cNvSpPr/>
          <p:nvPr/>
        </p:nvSpPr>
        <p:spPr>
          <a:xfrm rot="19364180">
            <a:off x="967079" y="3941320"/>
            <a:ext cx="107753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single-organism metabol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6" name="矩形 55"/>
          <p:cNvSpPr/>
          <p:nvPr/>
        </p:nvSpPr>
        <p:spPr>
          <a:xfrm rot="19364180">
            <a:off x="1309869" y="3859791"/>
            <a:ext cx="808235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single-organism </a:t>
            </a:r>
            <a:r>
              <a:rPr lang="en-US" altLang="zh-CN" sz="500" dirty="0" smtClean="0">
                <a:latin typeface="Times New Roman" pitchFamily="18" charset="0"/>
                <a:cs typeface="Times New Roman" pitchFamily="18" charset="0"/>
              </a:rPr>
              <a:t>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矩形 56"/>
          <p:cNvSpPr/>
          <p:nvPr/>
        </p:nvSpPr>
        <p:spPr>
          <a:xfrm rot="19364180">
            <a:off x="1563958" y="3803982"/>
            <a:ext cx="62388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defense response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8" name="矩形 57"/>
          <p:cNvSpPr/>
          <p:nvPr/>
        </p:nvSpPr>
        <p:spPr>
          <a:xfrm rot="19364180">
            <a:off x="1361303" y="3906379"/>
            <a:ext cx="96212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defense response to bacterium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9" name="矩形 58"/>
          <p:cNvSpPr/>
          <p:nvPr/>
        </p:nvSpPr>
        <p:spPr>
          <a:xfrm rot="19364180">
            <a:off x="1523495" y="3881629"/>
            <a:ext cx="88036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defense response to </a:t>
            </a:r>
            <a:r>
              <a:rPr lang="en-US" altLang="zh-CN" sz="500" dirty="0" smtClean="0">
                <a:latin typeface="Times New Roman" pitchFamily="18" charset="0"/>
                <a:cs typeface="Times New Roman" pitchFamily="18" charset="0"/>
              </a:rPr>
              <a:t>fungu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0" name="矩形 59"/>
          <p:cNvSpPr/>
          <p:nvPr/>
        </p:nvSpPr>
        <p:spPr>
          <a:xfrm rot="19364180">
            <a:off x="2127295" y="3807864"/>
            <a:ext cx="63671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response to str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1" name="矩形 60"/>
          <p:cNvSpPr/>
          <p:nvPr/>
        </p:nvSpPr>
        <p:spPr>
          <a:xfrm rot="19364180">
            <a:off x="1536537" y="3913736"/>
            <a:ext cx="96532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fatty acid </a:t>
            </a:r>
            <a:r>
              <a:rPr lang="en-US" altLang="zh-CN" sz="500" dirty="0" smtClean="0">
                <a:latin typeface="Times New Roman" pitchFamily="18" charset="0"/>
                <a:cs typeface="Times New Roman" pitchFamily="18" charset="0"/>
              </a:rPr>
              <a:t>biosynthetic 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2" name="矩形 61"/>
          <p:cNvSpPr/>
          <p:nvPr/>
        </p:nvSpPr>
        <p:spPr>
          <a:xfrm rot="19364180">
            <a:off x="1790974" y="3889827"/>
            <a:ext cx="904414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response to biotic stimulu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3" name="矩形 62"/>
          <p:cNvSpPr/>
          <p:nvPr/>
        </p:nvSpPr>
        <p:spPr>
          <a:xfrm rot="19364180">
            <a:off x="1713082" y="3980664"/>
            <a:ext cx="120417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monocarboxylic acid metabol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4" name="矩形 63"/>
          <p:cNvSpPr/>
          <p:nvPr/>
        </p:nvSpPr>
        <p:spPr>
          <a:xfrm rot="19364180">
            <a:off x="2299691" y="3813110"/>
            <a:ext cx="64793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smtClean="0">
                <a:latin typeface="Times New Roman" pitchFamily="18" charset="0"/>
                <a:cs typeface="Times New Roman" pitchFamily="18" charset="0"/>
              </a:rPr>
              <a:t>metabolic 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5" name="矩形 64"/>
          <p:cNvSpPr/>
          <p:nvPr/>
        </p:nvSpPr>
        <p:spPr>
          <a:xfrm rot="19364180">
            <a:off x="2216874" y="3873577"/>
            <a:ext cx="841897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lipid biosynthet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6" name="矩形 65"/>
          <p:cNvSpPr/>
          <p:nvPr/>
        </p:nvSpPr>
        <p:spPr>
          <a:xfrm rot="19364180">
            <a:off x="2142375" y="3930926"/>
            <a:ext cx="1040670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organic acid biosynthet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7" name="矩形 66"/>
          <p:cNvSpPr/>
          <p:nvPr/>
        </p:nvSpPr>
        <p:spPr>
          <a:xfrm rot="19364180">
            <a:off x="2164543" y="3958465"/>
            <a:ext cx="1119217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arboxylic acid biosynthet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8" name="矩形 67"/>
          <p:cNvSpPr/>
          <p:nvPr/>
        </p:nvSpPr>
        <p:spPr>
          <a:xfrm rot="19364180">
            <a:off x="2374792" y="3918767"/>
            <a:ext cx="98937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ellular lipid metabol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9" name="矩形 68"/>
          <p:cNvSpPr/>
          <p:nvPr/>
        </p:nvSpPr>
        <p:spPr>
          <a:xfrm rot="19364180">
            <a:off x="2376194" y="3947618"/>
            <a:ext cx="109837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ell wall organization or biogenesi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0" name="矩形 69"/>
          <p:cNvSpPr/>
          <p:nvPr/>
        </p:nvSpPr>
        <p:spPr>
          <a:xfrm rot="19364180">
            <a:off x="2653114" y="3889164"/>
            <a:ext cx="891591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response to oxidative str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1" name="矩形 70"/>
          <p:cNvSpPr/>
          <p:nvPr/>
        </p:nvSpPr>
        <p:spPr>
          <a:xfrm rot="19364180">
            <a:off x="2836814" y="3856060"/>
            <a:ext cx="78899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hitin catabol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3" name="矩形 72"/>
          <p:cNvSpPr/>
          <p:nvPr/>
        </p:nvSpPr>
        <p:spPr>
          <a:xfrm rot="19364180">
            <a:off x="3117500" y="3822423"/>
            <a:ext cx="68480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extracellular region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4" name="矩形 73"/>
          <p:cNvSpPr/>
          <p:nvPr/>
        </p:nvSpPr>
        <p:spPr>
          <a:xfrm rot="19364180">
            <a:off x="3344798" y="3785566"/>
            <a:ext cx="535724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hem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binding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5" name="矩形 74"/>
          <p:cNvSpPr/>
          <p:nvPr/>
        </p:nvSpPr>
        <p:spPr>
          <a:xfrm rot="19364180">
            <a:off x="3221659" y="3860302"/>
            <a:ext cx="782587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oxidoreductas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6" name="矩形 75"/>
          <p:cNvSpPr/>
          <p:nvPr/>
        </p:nvSpPr>
        <p:spPr>
          <a:xfrm rot="19364180">
            <a:off x="3482596" y="3801733"/>
            <a:ext cx="59663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iron ion binding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7" name="矩形 76"/>
          <p:cNvSpPr/>
          <p:nvPr/>
        </p:nvSpPr>
        <p:spPr>
          <a:xfrm rot="19364180">
            <a:off x="3526035" y="3818548"/>
            <a:ext cx="657552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oenzyme binding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8" name="矩形 77"/>
          <p:cNvSpPr/>
          <p:nvPr/>
        </p:nvSpPr>
        <p:spPr>
          <a:xfrm rot="19364180">
            <a:off x="3272731" y="3937949"/>
            <a:ext cx="103906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UDP-</a:t>
            </a:r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glucosyltransferas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9" name="矩形 78"/>
          <p:cNvSpPr/>
          <p:nvPr/>
        </p:nvSpPr>
        <p:spPr>
          <a:xfrm rot="19364180">
            <a:off x="3746329" y="3807634"/>
            <a:ext cx="622285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chitinas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1" name="矩形 80"/>
          <p:cNvSpPr/>
          <p:nvPr/>
        </p:nvSpPr>
        <p:spPr>
          <a:xfrm rot="19364180">
            <a:off x="3888765" y="3826816"/>
            <a:ext cx="67197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peroxidase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2" name="矩形 81"/>
          <p:cNvSpPr/>
          <p:nvPr/>
        </p:nvSpPr>
        <p:spPr>
          <a:xfrm rot="19364180">
            <a:off x="3970686" y="3826816"/>
            <a:ext cx="67197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oenzyme binding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3" name="矩形 82"/>
          <p:cNvSpPr/>
          <p:nvPr/>
        </p:nvSpPr>
        <p:spPr>
          <a:xfrm rot="19364180">
            <a:off x="3742603" y="3933636"/>
            <a:ext cx="1039067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UDP-</a:t>
            </a:r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glycosyltransferas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4" name="矩形 83"/>
          <p:cNvSpPr/>
          <p:nvPr/>
        </p:nvSpPr>
        <p:spPr>
          <a:xfrm rot="19364180">
            <a:off x="4164383" y="3822383"/>
            <a:ext cx="67197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transferas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5" name="矩形 84"/>
          <p:cNvSpPr/>
          <p:nvPr/>
        </p:nvSpPr>
        <p:spPr>
          <a:xfrm rot="19364180">
            <a:off x="4034049" y="3897463"/>
            <a:ext cx="918841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pyridoxal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phosphate binding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6" name="矩形 85"/>
          <p:cNvSpPr/>
          <p:nvPr/>
        </p:nvSpPr>
        <p:spPr>
          <a:xfrm rot="19364180">
            <a:off x="3974670" y="3953330"/>
            <a:ext cx="1095172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flavin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adenine dinucleotide binding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7" name="矩形 86"/>
          <p:cNvSpPr/>
          <p:nvPr/>
        </p:nvSpPr>
        <p:spPr>
          <a:xfrm rot="19364180">
            <a:off x="4390659" y="3840149"/>
            <a:ext cx="729687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transaminase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8" name="矩形 87"/>
          <p:cNvSpPr/>
          <p:nvPr/>
        </p:nvSpPr>
        <p:spPr>
          <a:xfrm rot="19364180">
            <a:off x="1681022" y="3893045"/>
            <a:ext cx="904414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fatty acid metabol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2" name="矩形 91"/>
          <p:cNvSpPr/>
          <p:nvPr/>
        </p:nvSpPr>
        <p:spPr>
          <a:xfrm rot="19364180">
            <a:off x="1262873" y="5440656"/>
            <a:ext cx="62388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defense response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" name="矩形 92"/>
          <p:cNvSpPr/>
          <p:nvPr/>
        </p:nvSpPr>
        <p:spPr>
          <a:xfrm rot="19364180">
            <a:off x="1441264" y="5444682"/>
            <a:ext cx="63671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response to str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4" name="矩形 93"/>
          <p:cNvSpPr/>
          <p:nvPr/>
        </p:nvSpPr>
        <p:spPr>
          <a:xfrm rot="19364180">
            <a:off x="1113326" y="5525726"/>
            <a:ext cx="904414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response to biotic stimulu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5" name="矩形 94"/>
          <p:cNvSpPr/>
          <p:nvPr/>
        </p:nvSpPr>
        <p:spPr>
          <a:xfrm rot="19364180">
            <a:off x="1323489" y="5517726"/>
            <a:ext cx="872355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response to biotic stimulu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6" name="矩形 95"/>
          <p:cNvSpPr/>
          <p:nvPr/>
        </p:nvSpPr>
        <p:spPr>
          <a:xfrm rot="19364180">
            <a:off x="1545963" y="5480619"/>
            <a:ext cx="72808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embryo development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7" name="矩形 96"/>
          <p:cNvSpPr/>
          <p:nvPr/>
        </p:nvSpPr>
        <p:spPr>
          <a:xfrm rot="19364180">
            <a:off x="1496520" y="5526138"/>
            <a:ext cx="899605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ceramid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metabol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8" name="矩形 97"/>
          <p:cNvSpPr/>
          <p:nvPr/>
        </p:nvSpPr>
        <p:spPr>
          <a:xfrm rot="19364180">
            <a:off x="1739268" y="5483787"/>
            <a:ext cx="724877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response to chemical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9" name="矩形 98"/>
          <p:cNvSpPr/>
          <p:nvPr/>
        </p:nvSpPr>
        <p:spPr>
          <a:xfrm rot="19364180">
            <a:off x="1847437" y="5479648"/>
            <a:ext cx="72006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response to </a:t>
            </a:r>
            <a:r>
              <a:rPr lang="en-US" altLang="zh-CN" sz="500" dirty="0" smtClean="0">
                <a:latin typeface="Times New Roman" pitchFamily="18" charset="0"/>
                <a:cs typeface="Times New Roman" pitchFamily="18" charset="0"/>
              </a:rPr>
              <a:t>hormone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0" name="矩形 99"/>
          <p:cNvSpPr/>
          <p:nvPr/>
        </p:nvSpPr>
        <p:spPr>
          <a:xfrm rot="19364180">
            <a:off x="1984802" y="5458959"/>
            <a:ext cx="66877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metal ion transport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1" name="矩形 100"/>
          <p:cNvSpPr/>
          <p:nvPr/>
        </p:nvSpPr>
        <p:spPr>
          <a:xfrm rot="19364180">
            <a:off x="2104697" y="5446111"/>
            <a:ext cx="63510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response to auxin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2" name="矩形 101"/>
          <p:cNvSpPr/>
          <p:nvPr/>
        </p:nvSpPr>
        <p:spPr>
          <a:xfrm rot="19364180">
            <a:off x="1955712" y="5532363"/>
            <a:ext cx="906017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ytokinin metabol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3" name="矩形 102"/>
          <p:cNvSpPr/>
          <p:nvPr/>
        </p:nvSpPr>
        <p:spPr>
          <a:xfrm rot="19364180">
            <a:off x="1819111" y="5608464"/>
            <a:ext cx="115768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positive regulation of Notch </a:t>
            </a:r>
            <a:r>
              <a:rPr lang="en-US" altLang="zh-CN" sz="500" dirty="0" smtClean="0">
                <a:latin typeface="Times New Roman" pitchFamily="18" charset="0"/>
                <a:cs typeface="Times New Roman" pitchFamily="18" charset="0"/>
              </a:rPr>
              <a:t>signaling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4" name="矩形 103"/>
          <p:cNvSpPr/>
          <p:nvPr/>
        </p:nvSpPr>
        <p:spPr>
          <a:xfrm rot="19364180">
            <a:off x="1735280" y="5671384"/>
            <a:ext cx="137088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smtClean="0">
                <a:latin typeface="Times New Roman" pitchFamily="18" charset="0"/>
                <a:cs typeface="Times New Roman" pitchFamily="18" charset="0"/>
              </a:rPr>
              <a:t>de novo 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pyrimidine </a:t>
            </a:r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nucleobas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500" dirty="0" smtClean="0">
                <a:latin typeface="Times New Roman" pitchFamily="18" charset="0"/>
                <a:cs typeface="Times New Roman" pitchFamily="18" charset="0"/>
              </a:rPr>
              <a:t>biosynthesi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5" name="矩形 104"/>
          <p:cNvSpPr/>
          <p:nvPr/>
        </p:nvSpPr>
        <p:spPr>
          <a:xfrm rot="19364180">
            <a:off x="2712629" y="5371658"/>
            <a:ext cx="381835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nucleu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6" name="矩形 105"/>
          <p:cNvSpPr/>
          <p:nvPr/>
        </p:nvSpPr>
        <p:spPr>
          <a:xfrm rot="19364180">
            <a:off x="2633515" y="5434031"/>
            <a:ext cx="57419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SOSS complex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7" name="矩形 106"/>
          <p:cNvSpPr/>
          <p:nvPr/>
        </p:nvSpPr>
        <p:spPr>
          <a:xfrm rot="19364180">
            <a:off x="2699437" y="5442305"/>
            <a:ext cx="60785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smtClean="0">
                <a:latin typeface="Times New Roman" pitchFamily="18" charset="0"/>
                <a:cs typeface="Times New Roman" pitchFamily="18" charset="0"/>
              </a:rPr>
              <a:t>Mpp10 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omplex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8" name="矩形 107"/>
          <p:cNvSpPr/>
          <p:nvPr/>
        </p:nvSpPr>
        <p:spPr>
          <a:xfrm rot="19364180">
            <a:off x="2674241" y="5479647"/>
            <a:ext cx="74892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intracellular organelle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9" name="矩形 108"/>
          <p:cNvSpPr/>
          <p:nvPr/>
        </p:nvSpPr>
        <p:spPr>
          <a:xfrm rot="19364180">
            <a:off x="2960269" y="5416029"/>
            <a:ext cx="53572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DNA binding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0" name="矩形 109"/>
          <p:cNvSpPr/>
          <p:nvPr/>
        </p:nvSpPr>
        <p:spPr>
          <a:xfrm rot="19364180">
            <a:off x="2503123" y="5599491"/>
            <a:ext cx="1148070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ysteine-type </a:t>
            </a:r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endopeptidas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500" dirty="0" smtClean="0">
                <a:latin typeface="Times New Roman" pitchFamily="18" charset="0"/>
                <a:cs typeface="Times New Roman" pitchFamily="18" charset="0"/>
              </a:rPr>
              <a:t>inhibitor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1" name="矩形 110"/>
          <p:cNvSpPr/>
          <p:nvPr/>
        </p:nvSpPr>
        <p:spPr>
          <a:xfrm rot="19364180">
            <a:off x="2707194" y="5561894"/>
            <a:ext cx="1010212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sequence-specific DNA binding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2" name="矩形 111"/>
          <p:cNvSpPr/>
          <p:nvPr/>
        </p:nvSpPr>
        <p:spPr>
          <a:xfrm rot="19364180">
            <a:off x="2896193" y="5532776"/>
            <a:ext cx="914032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protein dimerization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3" name="矩形 112"/>
          <p:cNvSpPr/>
          <p:nvPr/>
        </p:nvSpPr>
        <p:spPr>
          <a:xfrm rot="19364180">
            <a:off x="3328585" y="5420167"/>
            <a:ext cx="53572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FMN binding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4" name="矩形 113"/>
          <p:cNvSpPr/>
          <p:nvPr/>
        </p:nvSpPr>
        <p:spPr>
          <a:xfrm rot="19364180">
            <a:off x="2837372" y="5622326"/>
            <a:ext cx="1196161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Rho </a:t>
            </a:r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guanyl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-nucleotide exchange factor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5" name="矩形 114"/>
          <p:cNvSpPr/>
          <p:nvPr/>
        </p:nvSpPr>
        <p:spPr>
          <a:xfrm rot="19364180">
            <a:off x="3067592" y="5568715"/>
            <a:ext cx="103746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ytokinin dehydrogenase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7" name="矩形 116"/>
          <p:cNvSpPr/>
          <p:nvPr/>
        </p:nvSpPr>
        <p:spPr>
          <a:xfrm rot="19364180">
            <a:off x="3605519" y="5452293"/>
            <a:ext cx="643125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hydrolase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8" name="矩形 117"/>
          <p:cNvSpPr/>
          <p:nvPr/>
        </p:nvSpPr>
        <p:spPr>
          <a:xfrm rot="19364180">
            <a:off x="3182901" y="5622595"/>
            <a:ext cx="122020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protein disulfide </a:t>
            </a:r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oxidoreductas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2" name="矩形 121"/>
          <p:cNvSpPr/>
          <p:nvPr/>
        </p:nvSpPr>
        <p:spPr>
          <a:xfrm rot="19364180">
            <a:off x="1851032" y="7113540"/>
            <a:ext cx="63671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response to str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3" name="矩形 122"/>
          <p:cNvSpPr/>
          <p:nvPr/>
        </p:nvSpPr>
        <p:spPr>
          <a:xfrm rot="19364180">
            <a:off x="1692273" y="7140421"/>
            <a:ext cx="710451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response to </a:t>
            </a:r>
            <a:r>
              <a:rPr lang="en-US" altLang="zh-CN" sz="500" dirty="0" smtClean="0">
                <a:latin typeface="Times New Roman" pitchFamily="18" charset="0"/>
                <a:cs typeface="Times New Roman" pitchFamily="18" charset="0"/>
              </a:rPr>
              <a:t>stimulu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4" name="矩形 123"/>
          <p:cNvSpPr/>
          <p:nvPr/>
        </p:nvSpPr>
        <p:spPr>
          <a:xfrm rot="19364180">
            <a:off x="1399682" y="7151677"/>
            <a:ext cx="72808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embryo development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5" name="矩形 124"/>
          <p:cNvSpPr/>
          <p:nvPr/>
        </p:nvSpPr>
        <p:spPr>
          <a:xfrm rot="19364180">
            <a:off x="1337195" y="7198358"/>
            <a:ext cx="899605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ceramid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metabol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6" name="矩形 125"/>
          <p:cNvSpPr/>
          <p:nvPr/>
        </p:nvSpPr>
        <p:spPr>
          <a:xfrm rot="19364180">
            <a:off x="1966687" y="7141701"/>
            <a:ext cx="72006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response to </a:t>
            </a:r>
            <a:r>
              <a:rPr lang="en-US" altLang="zh-CN" sz="500" dirty="0" smtClean="0">
                <a:latin typeface="Times New Roman" pitchFamily="18" charset="0"/>
                <a:cs typeface="Times New Roman" pitchFamily="18" charset="0"/>
              </a:rPr>
              <a:t>hormone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7" name="矩形 126"/>
          <p:cNvSpPr/>
          <p:nvPr/>
        </p:nvSpPr>
        <p:spPr>
          <a:xfrm rot="19364180">
            <a:off x="1917640" y="7133221"/>
            <a:ext cx="66877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metal ion transport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8" name="矩形 127"/>
          <p:cNvSpPr/>
          <p:nvPr/>
        </p:nvSpPr>
        <p:spPr>
          <a:xfrm rot="19364180">
            <a:off x="2135338" y="7117791"/>
            <a:ext cx="63510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response to auxin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9" name="矩形 128"/>
          <p:cNvSpPr/>
          <p:nvPr/>
        </p:nvSpPr>
        <p:spPr>
          <a:xfrm rot="19364180">
            <a:off x="2757688" y="7097938"/>
            <a:ext cx="57419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SOSS complex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0" name="矩形 129"/>
          <p:cNvSpPr/>
          <p:nvPr/>
        </p:nvSpPr>
        <p:spPr>
          <a:xfrm rot="19364180">
            <a:off x="3164323" y="7089616"/>
            <a:ext cx="53572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DNA binding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1" name="矩形 130"/>
          <p:cNvSpPr/>
          <p:nvPr/>
        </p:nvSpPr>
        <p:spPr>
          <a:xfrm rot="19364180">
            <a:off x="4192841" y="7085846"/>
            <a:ext cx="53572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FMN binding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2" name="矩形 131"/>
          <p:cNvSpPr/>
          <p:nvPr/>
        </p:nvSpPr>
        <p:spPr>
          <a:xfrm rot="19364180">
            <a:off x="1022675" y="7242706"/>
            <a:ext cx="104387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ellular </a:t>
            </a:r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glucan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metabol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3" name="矩形 132"/>
          <p:cNvSpPr/>
          <p:nvPr/>
        </p:nvSpPr>
        <p:spPr>
          <a:xfrm rot="19364180">
            <a:off x="961911" y="7226977"/>
            <a:ext cx="998991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arbohydrate metabol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4" name="矩形 133"/>
          <p:cNvSpPr/>
          <p:nvPr/>
        </p:nvSpPr>
        <p:spPr>
          <a:xfrm rot="19364180">
            <a:off x="2474816" y="7131424"/>
            <a:ext cx="68480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extracellular region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5" name="矩形 134"/>
          <p:cNvSpPr/>
          <p:nvPr/>
        </p:nvSpPr>
        <p:spPr>
          <a:xfrm rot="19364180">
            <a:off x="1773055" y="7086123"/>
            <a:ext cx="518091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pathogenesi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6" name="矩形 135"/>
          <p:cNvSpPr/>
          <p:nvPr/>
        </p:nvSpPr>
        <p:spPr>
          <a:xfrm rot="19364180">
            <a:off x="2340863" y="7088501"/>
            <a:ext cx="510075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ion transport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7" name="矩形 136"/>
          <p:cNvSpPr/>
          <p:nvPr/>
        </p:nvSpPr>
        <p:spPr>
          <a:xfrm rot="19364180">
            <a:off x="2376344" y="7108452"/>
            <a:ext cx="585417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cation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transport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8" name="矩形 137"/>
          <p:cNvSpPr/>
          <p:nvPr/>
        </p:nvSpPr>
        <p:spPr>
          <a:xfrm rot="19364180">
            <a:off x="2651577" y="7043028"/>
            <a:ext cx="381835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nucleu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9" name="矩形 138"/>
          <p:cNvSpPr/>
          <p:nvPr/>
        </p:nvSpPr>
        <p:spPr>
          <a:xfrm rot="19364180">
            <a:off x="2813521" y="7051691"/>
            <a:ext cx="39946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apoplast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0" name="矩形 139"/>
          <p:cNvSpPr/>
          <p:nvPr/>
        </p:nvSpPr>
        <p:spPr>
          <a:xfrm rot="19364180">
            <a:off x="2871749" y="7094613"/>
            <a:ext cx="53892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ell peripher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1" name="矩形 140"/>
          <p:cNvSpPr/>
          <p:nvPr/>
        </p:nvSpPr>
        <p:spPr>
          <a:xfrm rot="19364180">
            <a:off x="2485071" y="7255184"/>
            <a:ext cx="1088760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plasma membrane protein complex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2" name="矩形 141"/>
          <p:cNvSpPr/>
          <p:nvPr/>
        </p:nvSpPr>
        <p:spPr>
          <a:xfrm rot="19364180">
            <a:off x="2582568" y="7251859"/>
            <a:ext cx="1088760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heterotrimeric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G-protein complex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3" name="矩形 142"/>
          <p:cNvSpPr/>
          <p:nvPr/>
        </p:nvSpPr>
        <p:spPr>
          <a:xfrm rot="19364180">
            <a:off x="3056144" y="7165664"/>
            <a:ext cx="76495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alpha-amylase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4" name="矩形 143"/>
          <p:cNvSpPr/>
          <p:nvPr/>
        </p:nvSpPr>
        <p:spPr>
          <a:xfrm rot="19364180">
            <a:off x="3004830" y="7215257"/>
            <a:ext cx="926857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arbon-oxygen </a:t>
            </a:r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lyas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5" name="矩形 144"/>
          <p:cNvSpPr/>
          <p:nvPr/>
        </p:nvSpPr>
        <p:spPr>
          <a:xfrm rot="19364180">
            <a:off x="3037639" y="7236031"/>
            <a:ext cx="99738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endopeptidas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inhibitor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6" name="矩形 145"/>
          <p:cNvSpPr/>
          <p:nvPr/>
        </p:nvSpPr>
        <p:spPr>
          <a:xfrm rot="19364180">
            <a:off x="2990339" y="7278902"/>
            <a:ext cx="1148070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ysteine-type </a:t>
            </a:r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endopeptidas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500" dirty="0" smtClean="0">
                <a:latin typeface="Times New Roman" pitchFamily="18" charset="0"/>
                <a:cs typeface="Times New Roman" pitchFamily="18" charset="0"/>
              </a:rPr>
              <a:t>inhibitor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7" name="矩形 146"/>
          <p:cNvSpPr/>
          <p:nvPr/>
        </p:nvSpPr>
        <p:spPr>
          <a:xfrm rot="19364180">
            <a:off x="3402488" y="7168432"/>
            <a:ext cx="78258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electron carrier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8" name="矩形 147"/>
          <p:cNvSpPr/>
          <p:nvPr/>
        </p:nvSpPr>
        <p:spPr>
          <a:xfrm rot="19364180">
            <a:off x="3287519" y="7237294"/>
            <a:ext cx="1019830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err="1" smtClean="0">
                <a:latin typeface="Times New Roman" pitchFamily="18" charset="0"/>
                <a:cs typeface="Times New Roman" pitchFamily="18" charset="0"/>
              </a:rPr>
              <a:t>xyloglucosyl</a:t>
            </a:r>
            <a:r>
              <a:rPr lang="en-US" altLang="zh-CN" sz="5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transferas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9" name="矩形 148"/>
          <p:cNvSpPr/>
          <p:nvPr/>
        </p:nvSpPr>
        <p:spPr>
          <a:xfrm rot="19364180">
            <a:off x="3331569" y="7256165"/>
            <a:ext cx="1083951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tRNA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-intron endonuclease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0" name="矩形 149"/>
          <p:cNvSpPr/>
          <p:nvPr/>
        </p:nvSpPr>
        <p:spPr>
          <a:xfrm rot="19364180">
            <a:off x="3567230" y="7206036"/>
            <a:ext cx="92685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ion channel inhibitor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1" name="矩形 150"/>
          <p:cNvSpPr/>
          <p:nvPr/>
        </p:nvSpPr>
        <p:spPr>
          <a:xfrm rot="19364180">
            <a:off x="3877158" y="7132118"/>
            <a:ext cx="67197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transferas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2" name="矩形 151"/>
          <p:cNvSpPr/>
          <p:nvPr/>
        </p:nvSpPr>
        <p:spPr>
          <a:xfrm rot="19364180">
            <a:off x="4001313" y="7125469"/>
            <a:ext cx="643125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hydrolase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3" name="矩形 152"/>
          <p:cNvSpPr/>
          <p:nvPr/>
        </p:nvSpPr>
        <p:spPr>
          <a:xfrm rot="19364180">
            <a:off x="4037429" y="7175999"/>
            <a:ext cx="82105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terpen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synthase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4" name="矩形 153"/>
          <p:cNvSpPr/>
          <p:nvPr/>
        </p:nvSpPr>
        <p:spPr>
          <a:xfrm rot="19364180">
            <a:off x="4241190" y="7138378"/>
            <a:ext cx="697627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alcium ion binding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5" name="矩形 154"/>
          <p:cNvSpPr/>
          <p:nvPr/>
        </p:nvSpPr>
        <p:spPr>
          <a:xfrm rot="19364180">
            <a:off x="4194905" y="7188185"/>
            <a:ext cx="856325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iron-sulfur cluster binding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6" name="矩形 155"/>
          <p:cNvSpPr/>
          <p:nvPr/>
        </p:nvSpPr>
        <p:spPr>
          <a:xfrm rot="19364180">
            <a:off x="4490405" y="7124773"/>
            <a:ext cx="636713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peptidase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57" name="Picture 4" descr="C:\Users\Administrator\Desktop\result\client708_up&amp;down\client.GO_Enrich.barplot_708_9311NILup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459" t="8409" r="1522" b="48873"/>
          <a:stretch/>
        </p:blipFill>
        <p:spPr bwMode="auto">
          <a:xfrm>
            <a:off x="5087525" y="6080084"/>
            <a:ext cx="238803" cy="9765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3" name="矩形 32"/>
          <p:cNvSpPr/>
          <p:nvPr/>
        </p:nvSpPr>
        <p:spPr>
          <a:xfrm rot="19364180">
            <a:off x="4003938" y="2336713"/>
            <a:ext cx="1298752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serine-type </a:t>
            </a:r>
            <a:r>
              <a:rPr lang="en-US" altLang="zh-CN" sz="500" dirty="0" err="1">
                <a:latin typeface="Times New Roman" pitchFamily="18" charset="0"/>
                <a:cs typeface="Times New Roman" pitchFamily="18" charset="0"/>
              </a:rPr>
              <a:t>endopeptidase</a:t>
            </a:r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 inhibitor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2" name="矩形 71"/>
          <p:cNvSpPr/>
          <p:nvPr/>
        </p:nvSpPr>
        <p:spPr>
          <a:xfrm rot="19364180">
            <a:off x="2489695" y="4001012"/>
            <a:ext cx="127470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ell wall macromolecule catabolic process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0" name="矩形 79"/>
          <p:cNvSpPr/>
          <p:nvPr/>
        </p:nvSpPr>
        <p:spPr>
          <a:xfrm rot="19364180">
            <a:off x="3258775" y="4004664"/>
            <a:ext cx="1273105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cellulose synthase (UDP-forming)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6" name="矩形 115"/>
          <p:cNvSpPr/>
          <p:nvPr/>
        </p:nvSpPr>
        <p:spPr>
          <a:xfrm rot="19364180">
            <a:off x="2880768" y="5661559"/>
            <a:ext cx="1354858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500" dirty="0">
                <a:latin typeface="Times New Roman" pitchFamily="18" charset="0"/>
                <a:cs typeface="Times New Roman" pitchFamily="18" charset="0"/>
              </a:rPr>
              <a:t>orotidine-5'-phosphate decarboxylase activity</a:t>
            </a:r>
            <a:endParaRPr lang="zh-CN" altLang="en-US" sz="5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3" name="Picture 2" descr="C:\Users\Administrator\Desktop\result\client708_up&amp;down\client.GO_Enrich.barplot_708_9311down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836" t="8508" r="1618" b="49064"/>
          <a:stretch/>
        </p:blipFill>
        <p:spPr bwMode="auto">
          <a:xfrm>
            <a:off x="5096389" y="1109317"/>
            <a:ext cx="229939" cy="9698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0" name="TextBox 159"/>
          <p:cNvSpPr txBox="1"/>
          <p:nvPr/>
        </p:nvSpPr>
        <p:spPr>
          <a:xfrm>
            <a:off x="748748" y="7968570"/>
            <a:ext cx="555902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5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O analysis the up or down-regulated DEPs. (a, b) The down-regulated DEPs in hybrid vs. 9311 (a) and hybrid vs. 9311-NIL (b) compare groups. (c, d)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up-regulated DEPs in hybrid vs. 9311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hybrid vs.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311-NIL (d)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e groups. BP, Biological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cesses. CC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ellular components. MF, molecular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nctions.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1759666" y="1185858"/>
            <a:ext cx="1836000" cy="21328"/>
          </a:xfrm>
          <a:prstGeom prst="rect">
            <a:avLst/>
          </a:prstGeom>
          <a:solidFill>
            <a:srgbClr val="A22E4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/>
          </a:p>
        </p:txBody>
      </p:sp>
      <p:sp>
        <p:nvSpPr>
          <p:cNvPr id="35" name="矩形 34"/>
          <p:cNvSpPr/>
          <p:nvPr/>
        </p:nvSpPr>
        <p:spPr>
          <a:xfrm>
            <a:off x="3627476" y="1186329"/>
            <a:ext cx="169600" cy="21600"/>
          </a:xfrm>
          <a:prstGeom prst="rect">
            <a:avLst/>
          </a:prstGeom>
          <a:solidFill>
            <a:srgbClr val="9B5DAF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/>
          </a:p>
        </p:txBody>
      </p:sp>
      <p:sp>
        <p:nvSpPr>
          <p:cNvPr id="165" name="矩形 164"/>
          <p:cNvSpPr/>
          <p:nvPr/>
        </p:nvSpPr>
        <p:spPr>
          <a:xfrm>
            <a:off x="3818957" y="1186329"/>
            <a:ext cx="1269773" cy="21600"/>
          </a:xfrm>
          <a:prstGeom prst="rect">
            <a:avLst/>
          </a:prstGeom>
          <a:solidFill>
            <a:srgbClr val="FC7B10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/>
          </a:p>
        </p:txBody>
      </p:sp>
      <p:sp>
        <p:nvSpPr>
          <p:cNvPr id="166" name="矩形 165"/>
          <p:cNvSpPr/>
          <p:nvPr/>
        </p:nvSpPr>
        <p:spPr>
          <a:xfrm>
            <a:off x="2501684" y="1107763"/>
            <a:ext cx="279244" cy="126129"/>
          </a:xfrm>
          <a:prstGeom prst="rect">
            <a:avLst/>
          </a:prstGeom>
        </p:spPr>
        <p:txBody>
          <a:bodyPr wrap="none" anchor="b">
            <a:spAutoFit/>
          </a:bodyPr>
          <a:lstStyle/>
          <a:p>
            <a:r>
              <a:rPr lang="en-US" altLang="zh-CN" sz="600" dirty="0" smtClean="0">
                <a:latin typeface="Times New Roman" pitchFamily="18" charset="0"/>
                <a:cs typeface="Times New Roman" pitchFamily="18" charset="0"/>
              </a:rPr>
              <a:t>BP</a:t>
            </a:r>
            <a:endParaRPr lang="zh-CN" altLang="en-US" sz="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7" name="矩形 166"/>
          <p:cNvSpPr/>
          <p:nvPr/>
        </p:nvSpPr>
        <p:spPr>
          <a:xfrm>
            <a:off x="3578814" y="1107763"/>
            <a:ext cx="287258" cy="126129"/>
          </a:xfrm>
          <a:prstGeom prst="rect">
            <a:avLst/>
          </a:prstGeom>
        </p:spPr>
        <p:txBody>
          <a:bodyPr wrap="none" anchor="b">
            <a:spAutoFit/>
          </a:bodyPr>
          <a:lstStyle/>
          <a:p>
            <a:r>
              <a:rPr lang="en-US" altLang="zh-CN" sz="600" dirty="0" smtClean="0">
                <a:latin typeface="Times New Roman" pitchFamily="18" charset="0"/>
                <a:cs typeface="Times New Roman" pitchFamily="18" charset="0"/>
              </a:rPr>
              <a:t>CC</a:t>
            </a:r>
            <a:endParaRPr lang="zh-CN" altLang="en-US" sz="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8" name="矩形 167"/>
          <p:cNvSpPr/>
          <p:nvPr/>
        </p:nvSpPr>
        <p:spPr>
          <a:xfrm>
            <a:off x="4278850" y="1107763"/>
            <a:ext cx="296876" cy="126129"/>
          </a:xfrm>
          <a:prstGeom prst="rect">
            <a:avLst/>
          </a:prstGeom>
        </p:spPr>
        <p:txBody>
          <a:bodyPr wrap="none" anchor="b">
            <a:spAutoFit/>
          </a:bodyPr>
          <a:lstStyle/>
          <a:p>
            <a:r>
              <a:rPr lang="en-US" altLang="zh-CN" sz="600" dirty="0" smtClean="0">
                <a:latin typeface="Times New Roman" pitchFamily="18" charset="0"/>
                <a:cs typeface="Times New Roman" pitchFamily="18" charset="0"/>
              </a:rPr>
              <a:t>MF</a:t>
            </a:r>
            <a:endParaRPr lang="zh-CN" altLang="en-US" sz="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9" name="矩形 168"/>
          <p:cNvSpPr/>
          <p:nvPr/>
        </p:nvSpPr>
        <p:spPr>
          <a:xfrm>
            <a:off x="1734707" y="2823874"/>
            <a:ext cx="1843200" cy="21600"/>
          </a:xfrm>
          <a:prstGeom prst="rect">
            <a:avLst/>
          </a:prstGeom>
          <a:solidFill>
            <a:srgbClr val="A22E4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/>
          </a:p>
        </p:txBody>
      </p:sp>
      <p:sp>
        <p:nvSpPr>
          <p:cNvPr id="170" name="矩形 169"/>
          <p:cNvSpPr/>
          <p:nvPr/>
        </p:nvSpPr>
        <p:spPr>
          <a:xfrm>
            <a:off x="3593112" y="2823874"/>
            <a:ext cx="105308" cy="21600"/>
          </a:xfrm>
          <a:prstGeom prst="rect">
            <a:avLst/>
          </a:prstGeom>
          <a:solidFill>
            <a:srgbClr val="9B5DAF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/>
          </a:p>
        </p:txBody>
      </p:sp>
      <p:sp>
        <p:nvSpPr>
          <p:cNvPr id="171" name="矩形 170"/>
          <p:cNvSpPr/>
          <p:nvPr/>
        </p:nvSpPr>
        <p:spPr>
          <a:xfrm>
            <a:off x="3712276" y="2823874"/>
            <a:ext cx="1360800" cy="21600"/>
          </a:xfrm>
          <a:prstGeom prst="rect">
            <a:avLst/>
          </a:prstGeom>
          <a:solidFill>
            <a:srgbClr val="FC7B10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/>
          </a:p>
        </p:txBody>
      </p:sp>
      <p:sp>
        <p:nvSpPr>
          <p:cNvPr id="172" name="矩形 171"/>
          <p:cNvSpPr/>
          <p:nvPr/>
        </p:nvSpPr>
        <p:spPr>
          <a:xfrm>
            <a:off x="2511732" y="2745308"/>
            <a:ext cx="279244" cy="126129"/>
          </a:xfrm>
          <a:prstGeom prst="rect">
            <a:avLst/>
          </a:prstGeom>
        </p:spPr>
        <p:txBody>
          <a:bodyPr wrap="none" anchor="b">
            <a:spAutoFit/>
          </a:bodyPr>
          <a:lstStyle/>
          <a:p>
            <a:r>
              <a:rPr lang="en-US" altLang="zh-CN" sz="600" dirty="0" smtClean="0">
                <a:latin typeface="Times New Roman" pitchFamily="18" charset="0"/>
                <a:cs typeface="Times New Roman" pitchFamily="18" charset="0"/>
              </a:rPr>
              <a:t>BP</a:t>
            </a:r>
            <a:endParaRPr lang="zh-CN" altLang="en-US" sz="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3" name="矩形 172"/>
          <p:cNvSpPr/>
          <p:nvPr/>
        </p:nvSpPr>
        <p:spPr>
          <a:xfrm>
            <a:off x="3506032" y="2745308"/>
            <a:ext cx="287258" cy="126129"/>
          </a:xfrm>
          <a:prstGeom prst="rect">
            <a:avLst/>
          </a:prstGeom>
        </p:spPr>
        <p:txBody>
          <a:bodyPr wrap="none" anchor="b">
            <a:spAutoFit/>
          </a:bodyPr>
          <a:lstStyle/>
          <a:p>
            <a:r>
              <a:rPr lang="en-US" altLang="zh-CN" sz="600" dirty="0" smtClean="0">
                <a:latin typeface="Times New Roman" pitchFamily="18" charset="0"/>
                <a:cs typeface="Times New Roman" pitchFamily="18" charset="0"/>
              </a:rPr>
              <a:t>CC</a:t>
            </a:r>
            <a:endParaRPr lang="zh-CN" altLang="en-US" sz="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4" name="矩形 173"/>
          <p:cNvSpPr/>
          <p:nvPr/>
        </p:nvSpPr>
        <p:spPr>
          <a:xfrm>
            <a:off x="4233795" y="2745308"/>
            <a:ext cx="296876" cy="126129"/>
          </a:xfrm>
          <a:prstGeom prst="rect">
            <a:avLst/>
          </a:prstGeom>
        </p:spPr>
        <p:txBody>
          <a:bodyPr wrap="none" anchor="b">
            <a:spAutoFit/>
          </a:bodyPr>
          <a:lstStyle/>
          <a:p>
            <a:r>
              <a:rPr lang="en-US" altLang="zh-CN" sz="600" dirty="0" smtClean="0">
                <a:latin typeface="Times New Roman" pitchFamily="18" charset="0"/>
                <a:cs typeface="Times New Roman" pitchFamily="18" charset="0"/>
              </a:rPr>
              <a:t>MF</a:t>
            </a:r>
            <a:endParaRPr lang="zh-CN" altLang="en-US" sz="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5" name="矩形 174"/>
          <p:cNvSpPr/>
          <p:nvPr/>
        </p:nvSpPr>
        <p:spPr>
          <a:xfrm>
            <a:off x="1754803" y="4548512"/>
            <a:ext cx="1165810" cy="21600"/>
          </a:xfrm>
          <a:prstGeom prst="rect">
            <a:avLst/>
          </a:prstGeom>
          <a:solidFill>
            <a:srgbClr val="A22E4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/>
          </a:p>
        </p:txBody>
      </p:sp>
      <p:sp>
        <p:nvSpPr>
          <p:cNvPr id="176" name="矩形 175"/>
          <p:cNvSpPr/>
          <p:nvPr/>
        </p:nvSpPr>
        <p:spPr>
          <a:xfrm>
            <a:off x="2940015" y="4548983"/>
            <a:ext cx="360000" cy="21600"/>
          </a:xfrm>
          <a:prstGeom prst="rect">
            <a:avLst/>
          </a:prstGeom>
          <a:solidFill>
            <a:srgbClr val="9B5DAF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/>
          </a:p>
        </p:txBody>
      </p:sp>
      <p:sp>
        <p:nvSpPr>
          <p:cNvPr id="177" name="矩形 176"/>
          <p:cNvSpPr/>
          <p:nvPr/>
        </p:nvSpPr>
        <p:spPr>
          <a:xfrm>
            <a:off x="3326847" y="4548983"/>
            <a:ext cx="914400" cy="21600"/>
          </a:xfrm>
          <a:prstGeom prst="rect">
            <a:avLst/>
          </a:prstGeom>
          <a:solidFill>
            <a:srgbClr val="FC7B10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/>
          </a:p>
        </p:txBody>
      </p:sp>
      <p:sp>
        <p:nvSpPr>
          <p:cNvPr id="178" name="矩形 177"/>
          <p:cNvSpPr/>
          <p:nvPr/>
        </p:nvSpPr>
        <p:spPr>
          <a:xfrm>
            <a:off x="2224960" y="4470418"/>
            <a:ext cx="279244" cy="126129"/>
          </a:xfrm>
          <a:prstGeom prst="rect">
            <a:avLst/>
          </a:prstGeom>
        </p:spPr>
        <p:txBody>
          <a:bodyPr wrap="none" anchor="b">
            <a:spAutoFit/>
          </a:bodyPr>
          <a:lstStyle/>
          <a:p>
            <a:r>
              <a:rPr lang="en-US" altLang="zh-CN" sz="600" dirty="0" smtClean="0">
                <a:latin typeface="Times New Roman" pitchFamily="18" charset="0"/>
                <a:cs typeface="Times New Roman" pitchFamily="18" charset="0"/>
              </a:rPr>
              <a:t>BP</a:t>
            </a:r>
            <a:endParaRPr lang="zh-CN" altLang="en-US" sz="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9" name="矩形 178"/>
          <p:cNvSpPr/>
          <p:nvPr/>
        </p:nvSpPr>
        <p:spPr>
          <a:xfrm>
            <a:off x="2971832" y="4470418"/>
            <a:ext cx="287258" cy="126129"/>
          </a:xfrm>
          <a:prstGeom prst="rect">
            <a:avLst/>
          </a:prstGeom>
        </p:spPr>
        <p:txBody>
          <a:bodyPr wrap="none" anchor="b">
            <a:spAutoFit/>
          </a:bodyPr>
          <a:lstStyle/>
          <a:p>
            <a:r>
              <a:rPr lang="en-US" altLang="zh-CN" sz="600" dirty="0" smtClean="0">
                <a:latin typeface="Times New Roman" pitchFamily="18" charset="0"/>
                <a:cs typeface="Times New Roman" pitchFamily="18" charset="0"/>
              </a:rPr>
              <a:t>CC</a:t>
            </a:r>
            <a:endParaRPr lang="zh-CN" altLang="en-US" sz="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0" name="矩形 179"/>
          <p:cNvSpPr/>
          <p:nvPr/>
        </p:nvSpPr>
        <p:spPr>
          <a:xfrm>
            <a:off x="3640000" y="4470418"/>
            <a:ext cx="296876" cy="126129"/>
          </a:xfrm>
          <a:prstGeom prst="rect">
            <a:avLst/>
          </a:prstGeom>
        </p:spPr>
        <p:txBody>
          <a:bodyPr wrap="none" anchor="b">
            <a:spAutoFit/>
          </a:bodyPr>
          <a:lstStyle/>
          <a:p>
            <a:r>
              <a:rPr lang="en-US" altLang="zh-CN" sz="600" dirty="0" smtClean="0">
                <a:latin typeface="Times New Roman" pitchFamily="18" charset="0"/>
                <a:cs typeface="Times New Roman" pitchFamily="18" charset="0"/>
              </a:rPr>
              <a:t>MF</a:t>
            </a:r>
            <a:endParaRPr lang="zh-CN" altLang="en-US" sz="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1" name="矩形 180"/>
          <p:cNvSpPr/>
          <p:nvPr/>
        </p:nvSpPr>
        <p:spPr>
          <a:xfrm>
            <a:off x="1769875" y="6264053"/>
            <a:ext cx="1080000" cy="21600"/>
          </a:xfrm>
          <a:prstGeom prst="rect">
            <a:avLst/>
          </a:prstGeom>
          <a:solidFill>
            <a:srgbClr val="A22E4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/>
          </a:p>
        </p:txBody>
      </p:sp>
      <p:sp>
        <p:nvSpPr>
          <p:cNvPr id="182" name="矩形 181"/>
          <p:cNvSpPr/>
          <p:nvPr/>
        </p:nvSpPr>
        <p:spPr>
          <a:xfrm>
            <a:off x="2876477" y="6264524"/>
            <a:ext cx="633600" cy="21600"/>
          </a:xfrm>
          <a:prstGeom prst="rect">
            <a:avLst/>
          </a:prstGeom>
          <a:solidFill>
            <a:srgbClr val="9B5DAF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/>
          </a:p>
        </p:txBody>
      </p:sp>
      <p:sp>
        <p:nvSpPr>
          <p:cNvPr id="183" name="矩形 182"/>
          <p:cNvSpPr/>
          <p:nvPr/>
        </p:nvSpPr>
        <p:spPr>
          <a:xfrm>
            <a:off x="3532403" y="6264524"/>
            <a:ext cx="1512000" cy="21600"/>
          </a:xfrm>
          <a:prstGeom prst="rect">
            <a:avLst/>
          </a:prstGeom>
          <a:solidFill>
            <a:srgbClr val="FC7B10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/>
          </a:p>
        </p:txBody>
      </p:sp>
      <p:sp>
        <p:nvSpPr>
          <p:cNvPr id="184" name="矩形 183"/>
          <p:cNvSpPr/>
          <p:nvPr/>
        </p:nvSpPr>
        <p:spPr>
          <a:xfrm>
            <a:off x="2199840" y="6185959"/>
            <a:ext cx="279244" cy="126129"/>
          </a:xfrm>
          <a:prstGeom prst="rect">
            <a:avLst/>
          </a:prstGeom>
        </p:spPr>
        <p:txBody>
          <a:bodyPr wrap="none" anchor="b">
            <a:spAutoFit/>
          </a:bodyPr>
          <a:lstStyle/>
          <a:p>
            <a:r>
              <a:rPr lang="en-US" altLang="zh-CN" sz="600" dirty="0" smtClean="0">
                <a:latin typeface="Times New Roman" pitchFamily="18" charset="0"/>
                <a:cs typeface="Times New Roman" pitchFamily="18" charset="0"/>
              </a:rPr>
              <a:t>BP</a:t>
            </a:r>
            <a:endParaRPr lang="zh-CN" altLang="en-US" sz="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5" name="矩形 184"/>
          <p:cNvSpPr/>
          <p:nvPr/>
        </p:nvSpPr>
        <p:spPr>
          <a:xfrm>
            <a:off x="3069734" y="6185959"/>
            <a:ext cx="287258" cy="126129"/>
          </a:xfrm>
          <a:prstGeom prst="rect">
            <a:avLst/>
          </a:prstGeom>
        </p:spPr>
        <p:txBody>
          <a:bodyPr wrap="none" anchor="b">
            <a:spAutoFit/>
          </a:bodyPr>
          <a:lstStyle/>
          <a:p>
            <a:r>
              <a:rPr lang="en-US" altLang="zh-CN" sz="600" dirty="0" smtClean="0">
                <a:latin typeface="Times New Roman" pitchFamily="18" charset="0"/>
                <a:cs typeface="Times New Roman" pitchFamily="18" charset="0"/>
              </a:rPr>
              <a:t>CC</a:t>
            </a:r>
            <a:endParaRPr lang="zh-CN" altLang="en-US" sz="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6" name="矩形 185"/>
          <p:cNvSpPr/>
          <p:nvPr/>
        </p:nvSpPr>
        <p:spPr>
          <a:xfrm>
            <a:off x="4112240" y="6185959"/>
            <a:ext cx="296876" cy="126129"/>
          </a:xfrm>
          <a:prstGeom prst="rect">
            <a:avLst/>
          </a:prstGeom>
        </p:spPr>
        <p:txBody>
          <a:bodyPr wrap="none" anchor="b">
            <a:spAutoFit/>
          </a:bodyPr>
          <a:lstStyle/>
          <a:p>
            <a:r>
              <a:rPr lang="en-US" altLang="zh-CN" sz="600" dirty="0" smtClean="0">
                <a:latin typeface="Times New Roman" pitchFamily="18" charset="0"/>
                <a:cs typeface="Times New Roman" pitchFamily="18" charset="0"/>
              </a:rPr>
              <a:t>MF</a:t>
            </a:r>
            <a:endParaRPr lang="zh-CN" altLang="en-US" sz="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1164622" y="1033736"/>
            <a:ext cx="341755" cy="18498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0" name="TextBox 189"/>
          <p:cNvSpPr txBox="1"/>
          <p:nvPr/>
        </p:nvSpPr>
        <p:spPr>
          <a:xfrm>
            <a:off x="1164622" y="2643318"/>
            <a:ext cx="341755" cy="246221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1" name="TextBox 190"/>
          <p:cNvSpPr txBox="1"/>
          <p:nvPr/>
        </p:nvSpPr>
        <p:spPr>
          <a:xfrm>
            <a:off x="1164622" y="4283157"/>
            <a:ext cx="341755" cy="246221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2" name="TextBox 191"/>
          <p:cNvSpPr txBox="1"/>
          <p:nvPr/>
        </p:nvSpPr>
        <p:spPr>
          <a:xfrm>
            <a:off x="1164622" y="5961683"/>
            <a:ext cx="341755" cy="246221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242526" y="611560"/>
            <a:ext cx="2625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upplementary Dat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362623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763820" y="3059832"/>
            <a:ext cx="555902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6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transcription level of </a:t>
            </a:r>
            <a:r>
              <a:rPr lang="en-US" altLang="zh-CN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AL1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mong three </a:t>
            </a:r>
            <a:r>
              <a:rPr lang="en-US" altLang="zh-CN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AL1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ines in young bud. The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represent mean ±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.d.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 = 5). Means labeled with different letters indicate significant difference at 5 % level by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key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Kramer test for multiple comparisons.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42526" y="611560"/>
            <a:ext cx="2625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upplementary Data</a:t>
            </a:r>
            <a:endParaRPr lang="zh-CN" altLang="en-US" dirty="0"/>
          </a:p>
        </p:txBody>
      </p:sp>
      <p:graphicFrame>
        <p:nvGraphicFramePr>
          <p:cNvPr id="23" name="图表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34361614"/>
              </p:ext>
            </p:extLst>
          </p:nvPr>
        </p:nvGraphicFramePr>
        <p:xfrm>
          <a:off x="2072762" y="1358605"/>
          <a:ext cx="20574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4" name="TextBox 23"/>
          <p:cNvSpPr txBox="1"/>
          <p:nvPr/>
        </p:nvSpPr>
        <p:spPr>
          <a:xfrm rot="16200000">
            <a:off x="1262766" y="1912256"/>
            <a:ext cx="15121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expression level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599398" y="1538273"/>
            <a:ext cx="216024" cy="173427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9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140968" y="1689207"/>
            <a:ext cx="216024" cy="230832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900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667604" y="1931531"/>
            <a:ext cx="216024" cy="230832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900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zh-CN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57326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34780873"/>
              </p:ext>
            </p:extLst>
          </p:nvPr>
        </p:nvGraphicFramePr>
        <p:xfrm>
          <a:off x="717550" y="1998097"/>
          <a:ext cx="5422900" cy="14478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435100"/>
                <a:gridCol w="3987800"/>
              </a:tblGrid>
              <a:tr h="1905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s</a:t>
                      </a:r>
                      <a:endParaRPr lang="zh-CN" sz="10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'</a:t>
                      </a:r>
                      <a:r>
                        <a:rPr lang="zh-CN" sz="10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→</a:t>
                      </a:r>
                      <a:r>
                        <a:rPr lang="en-US" sz="10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'</a:t>
                      </a:r>
                      <a:endParaRPr lang="zh-CN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L1-Anti-For1</a:t>
                      </a:r>
                      <a:endParaRPr lang="zh-CN" sz="10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CAGGTACCTGTTCTCCATCAATCCAACCG</a:t>
                      </a:r>
                      <a:endParaRPr lang="zh-CN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L1-Anti-Rev1</a:t>
                      </a:r>
                      <a:endParaRPr lang="zh-CN" sz="10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GAGGATCCACCAATACATTCGTCACTGCC</a:t>
                      </a:r>
                      <a:endParaRPr lang="zh-CN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L1-Real-For1</a:t>
                      </a:r>
                      <a:endParaRPr lang="zh-CN" sz="10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TGATCTTGGCCGTCTACTCG</a:t>
                      </a:r>
                      <a:endParaRPr lang="zh-CN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L1-Real-Rev1</a:t>
                      </a:r>
                      <a:endParaRPr lang="zh-CN" sz="10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CCCCAACAGCTGAGGTAAC</a:t>
                      </a:r>
                      <a:endParaRPr lang="zh-CN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bi-Real-For1</a:t>
                      </a:r>
                      <a:endParaRPr lang="zh-CN" sz="10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TCCAGGACAAGGAGGGG</a:t>
                      </a:r>
                      <a:endParaRPr lang="zh-CN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bi-Real-Rev1</a:t>
                      </a:r>
                      <a:endParaRPr lang="zh-CN" sz="10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GTAGTCGGCGAGGGTGC</a:t>
                      </a:r>
                      <a:endParaRPr lang="zh-CN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717551" y="1475656"/>
            <a:ext cx="5447754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able S1 The primers used </a:t>
            </a:r>
            <a:r>
              <a:rPr lang="en-US" altLang="zh-CN" sz="1000" dirty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in the recombinant </a:t>
            </a:r>
            <a:r>
              <a:rPr lang="en-US" altLang="zh-CN" sz="10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construct for </a:t>
            </a:r>
            <a:r>
              <a:rPr kumimoji="0" lang="en-US" altLang="zh-CN" sz="10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NAL1</a:t>
            </a: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lang="en-US" altLang="zh-CN" sz="10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antibody and expression </a:t>
            </a:r>
            <a:r>
              <a:rPr lang="en-US" altLang="zh-CN" sz="1000" dirty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level of </a:t>
            </a:r>
            <a:r>
              <a:rPr lang="en-US" altLang="zh-CN" sz="1000" i="1" dirty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NAL1</a:t>
            </a:r>
            <a:r>
              <a:rPr lang="en-US" altLang="zh-CN" sz="1000" dirty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in </a:t>
            </a:r>
            <a:r>
              <a:rPr lang="en-US" altLang="zh-CN" sz="1000" dirty="0" err="1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qRT</a:t>
            </a:r>
            <a:r>
              <a:rPr lang="en-US" altLang="zh-CN" sz="1000" dirty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-PCR.</a:t>
            </a:r>
            <a:endParaRPr kumimoji="0" lang="en-US" altLang="zh-CN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42526" y="611560"/>
            <a:ext cx="2625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upplementary Dat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156849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633</TotalTime>
  <Words>832</Words>
  <Application>Microsoft Office PowerPoint</Application>
  <PresentationFormat>全屏显示(4:3)</PresentationFormat>
  <Paragraphs>205</Paragraphs>
  <Slides>7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8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AL1 Heterosis</dc:title>
  <dc:creator>Administrator</dc:creator>
  <cp:lastModifiedBy>Lingling</cp:lastModifiedBy>
  <cp:revision>361</cp:revision>
  <dcterms:created xsi:type="dcterms:W3CDTF">2023-12-18T03:11:46Z</dcterms:created>
  <dcterms:modified xsi:type="dcterms:W3CDTF">2024-11-23T13:45:20Z</dcterms:modified>
</cp:coreProperties>
</file>